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4"/>
  </p:sldMasterIdLst>
  <p:notesMasterIdLst>
    <p:notesMasterId r:id="rId21"/>
  </p:notesMasterIdLst>
  <p:sldIdLst>
    <p:sldId id="546" r:id="rId5"/>
    <p:sldId id="547" r:id="rId6"/>
    <p:sldId id="548" r:id="rId7"/>
    <p:sldId id="549" r:id="rId8"/>
    <p:sldId id="550" r:id="rId9"/>
    <p:sldId id="551" r:id="rId10"/>
    <p:sldId id="552" r:id="rId11"/>
    <p:sldId id="553" r:id="rId12"/>
    <p:sldId id="554" r:id="rId13"/>
    <p:sldId id="555" r:id="rId14"/>
    <p:sldId id="556" r:id="rId15"/>
    <p:sldId id="557" r:id="rId16"/>
    <p:sldId id="558" r:id="rId17"/>
    <p:sldId id="559" r:id="rId18"/>
    <p:sldId id="560" r:id="rId19"/>
    <p:sldId id="561" r:id="rId20"/>
  </p:sldIdLst>
  <p:sldSz cx="7315200" cy="10058400"/>
  <p:notesSz cx="7010400" cy="9296400"/>
  <p:custDataLst>
    <p:tags r:id="rId22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75" userDrawn="1">
          <p15:clr>
            <a:srgbClr val="A4A3A4"/>
          </p15:clr>
        </p15:guide>
        <p15:guide id="2" pos="225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270C1"/>
    <a:srgbClr val="E97C30"/>
    <a:srgbClr val="2F5597"/>
    <a:srgbClr val="00B050"/>
    <a:srgbClr val="FE0011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inimized">
    <p:restoredLeft sz="0" autoAdjust="0"/>
    <p:restoredTop sz="92741" autoAdjust="0"/>
  </p:normalViewPr>
  <p:slideViewPr>
    <p:cSldViewPr snapToGrid="0" showGuides="1">
      <p:cViewPr varScale="1">
        <p:scale>
          <a:sx n="71" d="100"/>
          <a:sy n="71" d="100"/>
        </p:scale>
        <p:origin x="2106" y="54"/>
      </p:cViewPr>
      <p:guideLst>
        <p:guide orient="horz" pos="3175"/>
        <p:guide pos="225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62" d="100"/>
        <a:sy n="162" d="100"/>
      </p:scale>
      <p:origin x="0" y="279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openxmlformats.org/officeDocument/2006/relationships/tableStyles" Target="tableStyles.xml"/><Relationship Id="rId3" Type="http://schemas.openxmlformats.org/officeDocument/2006/relationships/customXml" Target="../customXml/item3.xml"/><Relationship Id="rId21" Type="http://schemas.openxmlformats.org/officeDocument/2006/relationships/notesMaster" Target="notesMasters/notesMaster1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theme" Target="theme/theme1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slide" Target="slides/slide16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viewProps" Target="viewProps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presProps" Target="presProps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tags" Target="tags/tag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26700;&#38754;\MDR2+BBR-paper\MDR2+BBR-all%20BA\20210107-Zhou%20results-Poop-CF%2048%20samples-CF-C%20(intestine)---------original%20results-less%20groups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D:\Chrome&#19979;&#36733;\&#32928;&#36947;&#33740;&#32676;\results\4.rarefied_table-12-05-all%20data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39.bin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Mdr2+BBR%20project-7-15-2021\Fecal%20microbes\Results\level-2.csv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Mdr2+BBR%20project-7-15-2021\Fecal%20microbes\Results\level-2.csv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Mdr2+BBR%20project-7-15-2021\Fecal%20microbes\Results\level-2.csv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26700;&#38754;\MDR2+BBR-paper\MDR2+BBR-all%20BA\20210107-Zhou%20results-Poop-CF%2048%20samples-CF-C%20(intestine)---------original%20results-less%20group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26700;&#38754;\MDR2+BBR-paper\MDR2+BBR-all%20BA\20210107-Zhou%20results-Poop-CF%2048%20samples-CF-C%20(feces)---------original%20results%20-%20less%20groups%20-%20final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26700;&#38754;\MDR2+BBR-paper\MDR2+BBR-all%20BA\20210107-Zhou%20results-Poop-CF%2048%20samples-CF-C%20(feces)---------original%20results%20-%20less%20groups%20-%20final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D:\Chrome&#19979;&#36733;\&#32928;&#36947;&#33740;&#32676;\results\4.rarefied_table-12-05-all%20data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D:\Chrome&#19979;&#36733;\&#32928;&#36947;&#33740;&#32676;\results\4.rarefied_table-12-05-all%20data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D:\Chrome&#19979;&#36733;\&#32928;&#36947;&#33740;&#32676;\results\4.rarefied_table-12-05-all%20dat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en-US" altLang="zh-CN" sz="1200" b="1" i="0" u="none" strike="noStrike" kern="1200" spc="0" baseline="0" dirty="0" smtClean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CN" sz="1200" b="1" i="0" u="none" strike="noStrike" kern="1200" spc="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ontrol</a:t>
            </a:r>
          </a:p>
        </c:rich>
      </c:tx>
      <c:layout>
        <c:manualLayout>
          <c:xMode val="edge"/>
          <c:yMode val="edge"/>
          <c:x val="0.430229444444444"/>
          <c:y val="0.104518469215916"/>
        </c:manualLayout>
      </c:layout>
      <c:overlay val="0"/>
      <c:spPr>
        <a:noFill/>
        <a:ln>
          <a:noFill/>
        </a:ln>
        <a:effectLst/>
      </c:spPr>
    </c:title>
    <c:autoTitleDeleted val="0"/>
    <c:view3D>
      <c:rotX val="30"/>
      <c:rotY val="0"/>
      <c:depthPercent val="100"/>
      <c:rAngAx val="0"/>
    </c:view3D>
    <c:floor>
      <c:thickness val="0"/>
      <c:spPr>
        <a:noFill/>
        <a:ln>
          <a:noFill/>
        </a:ln>
        <a:effectLst/>
      </c:spPr>
    </c:floor>
    <c:sideWall>
      <c:thickness val="0"/>
      <c:spPr>
        <a:noFill/>
        <a:ln>
          <a:noFill/>
        </a:ln>
        <a:effectLst/>
      </c:spPr>
    </c:sideWall>
    <c:backWall>
      <c:thickness val="0"/>
      <c:spPr>
        <a:noFill/>
        <a:ln>
          <a:noFill/>
        </a:ln>
        <a:effectLst/>
      </c:spPr>
    </c:backWall>
    <c:plotArea>
      <c:layout/>
      <c:pie3D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1-7DC9-49B7-943B-50E6C2606843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3-7DC9-49B7-943B-50E6C2606843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5-7DC9-49B7-943B-50E6C2606843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7-7DC9-49B7-943B-50E6C2606843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9-7DC9-49B7-943B-50E6C2606843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B-7DC9-49B7-943B-50E6C2606843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D-7DC9-49B7-943B-50E6C2606843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F-7DC9-49B7-943B-50E6C2606843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1-7DC9-49B7-943B-50E6C2606843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3-7DC9-49B7-943B-50E6C2606843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5-7DC9-49B7-943B-50E6C2606843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7-7DC9-49B7-943B-50E6C2606843}"/>
              </c:ext>
            </c:extLst>
          </c:dPt>
          <c:dPt>
            <c:idx val="12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9-7DC9-49B7-943B-50E6C2606843}"/>
              </c:ext>
            </c:extLst>
          </c:dPt>
          <c:dPt>
            <c:idx val="13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B-7DC9-49B7-943B-50E6C2606843}"/>
              </c:ext>
            </c:extLst>
          </c:dPt>
          <c:dPt>
            <c:idx val="14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D-7DC9-49B7-943B-50E6C2606843}"/>
              </c:ext>
            </c:extLst>
          </c:dPt>
          <c:dPt>
            <c:idx val="15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F-7DC9-49B7-943B-50E6C2606843}"/>
              </c:ext>
            </c:extLst>
          </c:dPt>
          <c:dLbls>
            <c:dLbl>
              <c:idx val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zh-CN" sz="900" b="0" i="0" u="none" strike="noStrike" kern="1200" baseline="0">
                      <a:solidFill>
                        <a:schemeClr val="bg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separator>
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7DC9-49B7-943B-50E6C2606843}"/>
                </c:ext>
              </c:extLst>
            </c:dLbl>
            <c:dLbl>
              <c:idx val="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7DC9-49B7-943B-50E6C2606843}"/>
                </c:ext>
              </c:extLst>
            </c:dLbl>
            <c:dLbl>
              <c:idx val="2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zh-CN" sz="900" b="0" i="0" u="none" strike="noStrike" kern="1200" baseline="0">
                      <a:solidFill>
                        <a:schemeClr val="bg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separator>
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7DC9-49B7-943B-50E6C2606843}"/>
                </c:ext>
              </c:extLst>
            </c:dLbl>
            <c:dLbl>
              <c:idx val="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7DC9-49B7-943B-50E6C2606843}"/>
                </c:ext>
              </c:extLst>
            </c:dLbl>
            <c:dLbl>
              <c:idx val="4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7DC9-49B7-943B-50E6C2606843}"/>
                </c:ext>
              </c:extLst>
            </c:dLbl>
            <c:dLbl>
              <c:idx val="5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7DC9-49B7-943B-50E6C2606843}"/>
                </c:ext>
              </c:extLst>
            </c:dLbl>
            <c:dLbl>
              <c:idx val="6"/>
              <c:layout>
                <c:manualLayout>
                  <c:x val="-1.64428373356829E-2"/>
                  <c:y val="-0.14126268097952599"/>
                </c:manualLayout>
              </c:layout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separator>
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7DC9-49B7-943B-50E6C2606843}"/>
                </c:ext>
              </c:extLst>
            </c:dLbl>
            <c:dLbl>
              <c:idx val="7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F-7DC9-49B7-943B-50E6C2606843}"/>
                </c:ext>
              </c:extLst>
            </c:dLbl>
            <c:dLbl>
              <c:idx val="8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1-7DC9-49B7-943B-50E6C2606843}"/>
                </c:ext>
              </c:extLst>
            </c:dLbl>
            <c:dLbl>
              <c:idx val="9"/>
              <c:layout>
                <c:manualLayout>
                  <c:x val="-3.7485555555555598E-2"/>
                  <c:y val="-1.1020731896753001E-2"/>
                </c:manualLayout>
              </c:layout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separator>
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3-7DC9-49B7-943B-50E6C2606843}"/>
                </c:ext>
              </c:extLst>
            </c:dLbl>
            <c:dLbl>
              <c:idx val="1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5-7DC9-49B7-943B-50E6C2606843}"/>
                </c:ext>
              </c:extLst>
            </c:dLbl>
            <c:dLbl>
              <c:idx val="1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7-7DC9-49B7-943B-50E6C2606843}"/>
                </c:ext>
              </c:extLst>
            </c:dLbl>
            <c:dLbl>
              <c:idx val="1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9-7DC9-49B7-943B-50E6C2606843}"/>
                </c:ext>
              </c:extLst>
            </c:dLbl>
            <c:dLbl>
              <c:idx val="1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B-7DC9-49B7-943B-50E6C2606843}"/>
                </c:ext>
              </c:extLst>
            </c:dLbl>
            <c:dLbl>
              <c:idx val="14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D-7DC9-49B7-943B-50E6C2606843}"/>
                </c:ext>
              </c:extLst>
            </c:dLbl>
            <c:dLbl>
              <c:idx val="15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F-7DC9-49B7-943B-50E6C260684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zh-CN"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bestFit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prstDash val="solid"/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Fecl-C-final'!$F$1:$U$1</c:f>
              <c:strCache>
                <c:ptCount val="16"/>
                <c:pt idx="0">
                  <c:v>TβMCA</c:v>
                </c:pt>
                <c:pt idx="1">
                  <c:v>GβMCA</c:v>
                </c:pt>
                <c:pt idx="2">
                  <c:v>TCA</c:v>
                </c:pt>
                <c:pt idx="3">
                  <c:v>GCA</c:v>
                </c:pt>
                <c:pt idx="4">
                  <c:v>TCDCA</c:v>
                </c:pt>
                <c:pt idx="5">
                  <c:v>TUDCA</c:v>
                </c:pt>
                <c:pt idx="6">
                  <c:v>βMCA</c:v>
                </c:pt>
                <c:pt idx="7">
                  <c:v>CA</c:v>
                </c:pt>
                <c:pt idx="8">
                  <c:v>CDCA</c:v>
                </c:pt>
                <c:pt idx="9">
                  <c:v>TωMCA</c:v>
                </c:pt>
                <c:pt idx="10">
                  <c:v>THDCA</c:v>
                </c:pt>
                <c:pt idx="11">
                  <c:v>TDCA</c:v>
                </c:pt>
                <c:pt idx="12">
                  <c:v>TLCA</c:v>
                </c:pt>
                <c:pt idx="13">
                  <c:v>GLCA</c:v>
                </c:pt>
                <c:pt idx="14">
                  <c:v>7keto_DCA</c:v>
                </c:pt>
                <c:pt idx="15">
                  <c:v>DCA</c:v>
                </c:pt>
              </c:strCache>
            </c:strRef>
          </c:cat>
          <c:val>
            <c:numRef>
              <c:f>'Fecl-C-final'!$F$26:$U$26</c:f>
              <c:numCache>
                <c:formatCode>0.00</c:formatCode>
                <c:ptCount val="16"/>
                <c:pt idx="0">
                  <c:v>0.32577784158456802</c:v>
                </c:pt>
                <c:pt idx="1">
                  <c:v>1.5265615270842301E-4</c:v>
                </c:pt>
                <c:pt idx="2">
                  <c:v>0.37061277185742197</c:v>
                </c:pt>
                <c:pt idx="3">
                  <c:v>3.1548292412538501E-4</c:v>
                </c:pt>
                <c:pt idx="4">
                  <c:v>2.2092347476645401E-3</c:v>
                </c:pt>
                <c:pt idx="5">
                  <c:v>3.0519311476898598E-3</c:v>
                </c:pt>
                <c:pt idx="6">
                  <c:v>5.4559167658720098E-2</c:v>
                </c:pt>
                <c:pt idx="7">
                  <c:v>8.7960898863485598E-2</c:v>
                </c:pt>
                <c:pt idx="8">
                  <c:v>1.5025571954138201E-4</c:v>
                </c:pt>
                <c:pt idx="9">
                  <c:v>0.149369538214222</c:v>
                </c:pt>
                <c:pt idx="10">
                  <c:v>3.24403465620821E-3</c:v>
                </c:pt>
                <c:pt idx="11">
                  <c:v>2.0558786466894101E-3</c:v>
                </c:pt>
                <c:pt idx="12">
                  <c:v>2.1337500282449801E-5</c:v>
                </c:pt>
                <c:pt idx="13">
                  <c:v>2.1188393256841399E-5</c:v>
                </c:pt>
                <c:pt idx="14">
                  <c:v>2.7714104970276801E-4</c:v>
                </c:pt>
                <c:pt idx="15">
                  <c:v>2.3653217865513701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0-7DC9-49B7-943B-50E6C2606843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  <c:showLeaderLines val="1"/>
        </c:dLbls>
      </c:pie3D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view3D>
      <c:rotX val="30"/>
      <c:rotY val="0"/>
      <c:depthPercent val="100"/>
      <c:rAngAx val="0"/>
    </c:view3D>
    <c:floor>
      <c:thickness val="0"/>
    </c:floor>
    <c:sideWall>
      <c:thickness val="0"/>
    </c:sideWall>
    <c:backWall>
      <c:thickness val="0"/>
    </c:backWall>
    <c:plotArea>
      <c:layout/>
      <c:pie3DChart>
        <c:varyColors val="1"/>
        <c:dLbls>
          <c:showLegendKey val="0"/>
          <c:showVal val="0"/>
          <c:showCatName val="0"/>
          <c:showSerName val="0"/>
          <c:showPercent val="0"/>
          <c:showBubbleSize val="0"/>
          <c:showLeaderLines val="0"/>
        </c:dLbls>
      </c:pie3DChart>
    </c:plotArea>
    <c:plotVisOnly val="1"/>
    <c:dispBlanksAs val="gap"/>
    <c:showDLblsOverMax val="0"/>
  </c:chart>
  <c:txPr>
    <a:bodyPr/>
    <a:lstStyle/>
    <a:p>
      <a:pPr>
        <a:defRPr lang="zh-CN"/>
      </a:pPr>
      <a:endParaRPr lang="en-US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view3D>
      <c:rotX val="30"/>
      <c:rotY val="0"/>
      <c:depthPercent val="100"/>
      <c:rAngAx val="0"/>
    </c:view3D>
    <c:floor>
      <c:thickness val="0"/>
    </c:floor>
    <c:sideWall>
      <c:thickness val="0"/>
    </c:sideWall>
    <c:backWall>
      <c:thickness val="0"/>
    </c:backWall>
    <c:plotArea>
      <c:layout>
        <c:manualLayout>
          <c:layoutTarget val="inner"/>
          <c:xMode val="edge"/>
          <c:yMode val="edge"/>
          <c:x val="0.49950442749159601"/>
          <c:y val="0.294159851640167"/>
          <c:w val="0.326955955511116"/>
          <c:h val="0.43742032245969198"/>
        </c:manualLayout>
      </c:layout>
      <c:pie3DChart>
        <c:varyColors val="1"/>
        <c:ser>
          <c:idx val="0"/>
          <c:order val="0"/>
          <c:dPt>
            <c:idx val="0"/>
            <c:bubble3D val="0"/>
            <c:explosion val="105"/>
            <c:spPr>
              <a:solidFill>
                <a:srgbClr val="E97C30"/>
              </a:solidFill>
            </c:spPr>
            <c:extLst>
              <c:ext xmlns:c16="http://schemas.microsoft.com/office/drawing/2014/chart" uri="{C3380CC4-5D6E-409C-BE32-E72D297353CC}">
                <c16:uniqueId val="{00000001-B513-47B4-A227-0A9023D111C6}"/>
              </c:ext>
            </c:extLst>
          </c:dPt>
          <c:dPt>
            <c:idx val="1"/>
            <c:bubble3D val="0"/>
            <c:spPr>
              <a:solidFill>
                <a:srgbClr val="4270C1"/>
              </a:solidFill>
            </c:spPr>
            <c:extLst>
              <c:ext xmlns:c16="http://schemas.microsoft.com/office/drawing/2014/chart" uri="{C3380CC4-5D6E-409C-BE32-E72D297353CC}">
                <c16:uniqueId val="{00000003-B513-47B4-A227-0A9023D111C6}"/>
              </c:ext>
            </c:extLst>
          </c:dPt>
          <c:dPt>
            <c:idx val="2"/>
            <c:bubble3D val="0"/>
            <c:extLst>
              <c:ext xmlns:c16="http://schemas.microsoft.com/office/drawing/2014/chart" uri="{C3380CC4-5D6E-409C-BE32-E72D297353CC}">
                <c16:uniqueId val="{00000004-B513-47B4-A227-0A9023D111C6}"/>
              </c:ext>
            </c:extLst>
          </c:dPt>
          <c:dLbls>
            <c:dLbl>
              <c:idx val="0"/>
              <c:layout>
                <c:manualLayout>
                  <c:x val="-0.123676640018792"/>
                  <c:y val="-0.162259300920718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B513-47B4-A227-0A9023D111C6}"/>
                </c:ext>
              </c:extLst>
            </c:dLbl>
            <c:dLbl>
              <c:idx val="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B513-47B4-A227-0A9023D111C6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0" vertOverflow="ellipsis" vert="horz" wrap="square" lIns="38100" tIns="19050" rIns="38100" bIns="19050" anchor="ctr" anchorCtr="1"/>
              <a:lstStyle/>
              <a:p>
                <a:pPr>
                  <a:defRPr lang="zh-CN"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bestFit"/>
            <c:showLegendKey val="0"/>
            <c:showVal val="0"/>
            <c:showCatName val="0"/>
            <c:showSerName val="0"/>
            <c:showPercent val="1"/>
            <c:showBubbleSize val="0"/>
            <c:showLeaderLines val="0"/>
            <c:extLst>
              <c:ext xmlns:c15="http://schemas.microsoft.com/office/drawing/2012/chart" uri="{CE6537A1-D6FC-4f65-9D91-7224C49458BB}"/>
            </c:extLst>
          </c:dLbls>
          <c:cat>
            <c:strRef>
              <c:f>'[4.rarefied_table-12-05-all data.xlsx]remove  grops'!$H$539:$H$541</c:f>
              <c:strCache>
                <c:ptCount val="3"/>
                <c:pt idx="0">
                  <c:v>Bacteroidetes</c:v>
                </c:pt>
                <c:pt idx="1">
                  <c:v>Firmicutes</c:v>
                </c:pt>
                <c:pt idx="2">
                  <c:v>Other</c:v>
                </c:pt>
              </c:strCache>
            </c:strRef>
          </c:cat>
          <c:val>
            <c:numRef>
              <c:f>'[4.rarefied_table-12-05-all data.xlsx]remove  grops'!$Y$539:$Y$541</c:f>
              <c:numCache>
                <c:formatCode>General</c:formatCode>
                <c:ptCount val="3"/>
                <c:pt idx="0">
                  <c:v>0.73388721804511103</c:v>
                </c:pt>
                <c:pt idx="1">
                  <c:v>0.25666917293232999</c:v>
                </c:pt>
                <c:pt idx="2">
                  <c:v>9.4436090225582907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B513-47B4-A227-0A9023D111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0"/>
        </c:dLbls>
      </c:pie3DChart>
    </c:plotArea>
    <c:legend>
      <c:legendPos val="r"/>
      <c:layout>
        <c:manualLayout>
          <c:xMode val="edge"/>
          <c:yMode val="edge"/>
          <c:x val="3.7382934817941998E-2"/>
          <c:y val="5.9357310065971502E-2"/>
          <c:w val="0.926689987120773"/>
          <c:h val="0.26352476210743903"/>
        </c:manualLayout>
      </c:layout>
      <c:overlay val="0"/>
      <c:txPr>
        <a:bodyPr rot="0" spcFirstLastPara="0" vertOverflow="ellipsis" vert="horz" wrap="square" anchor="ctr" anchorCtr="1"/>
        <a:lstStyle/>
        <a:p>
          <a:pPr>
            <a:defRPr lang="zh-CN" sz="14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lang="zh-CN"/>
      </a:pPr>
      <a:endParaRPr lang="en-US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en-US" altLang="zh-CN" sz="1200" b="1" i="0" u="none" strike="noStrike" kern="100" spc="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defRPr>
            </a:pPr>
            <a:r>
              <a:rPr lang="en-US" altLang="zh-CN" sz="1200" b="1" kern="100" dirty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ontrol</a:t>
            </a:r>
            <a:endParaRPr lang="en-US" altLang="zh-CN" sz="1200" b="1" kern="100" baseline="30000" dirty="0">
              <a:solidFill>
                <a:schemeClr val="tx1"/>
              </a:solidFill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8504324507024501"/>
          <c:y val="0.10129788917532399"/>
        </c:manualLayout>
      </c:layout>
      <c:overlay val="0"/>
      <c:spPr>
        <a:noFill/>
        <a:ln>
          <a:noFill/>
        </a:ln>
        <a:effectLst/>
      </c:spPr>
    </c:title>
    <c:autoTitleDeleted val="0"/>
    <c:view3D>
      <c:rotX val="30"/>
      <c:rotY val="0"/>
      <c:depthPercent val="100"/>
      <c:rAngAx val="0"/>
    </c:view3D>
    <c:floor>
      <c:thickness val="0"/>
      <c:spPr>
        <a:noFill/>
        <a:ln>
          <a:noFill/>
        </a:ln>
        <a:effectLst/>
      </c:spPr>
    </c:floor>
    <c:sideWall>
      <c:thickness val="0"/>
      <c:spPr>
        <a:noFill/>
        <a:ln>
          <a:noFill/>
        </a:ln>
        <a:effectLst/>
      </c:spPr>
    </c:sideWall>
    <c:backWall>
      <c:thickness val="0"/>
      <c:spPr>
        <a:noFill/>
        <a:ln>
          <a:noFill/>
        </a:ln>
        <a:effectLst/>
      </c:spPr>
    </c:backWall>
    <c:plotArea>
      <c:layout/>
      <c:pie3D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1-ABD1-4F74-A6E0-A76A6F779BC0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3-ABD1-4F74-A6E0-A76A6F779BC0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5-ABD1-4F74-A6E0-A76A6F779BC0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7-ABD1-4F74-A6E0-A76A6F779BC0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9-ABD1-4F74-A6E0-A76A6F779BC0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B-ABD1-4F74-A6E0-A76A6F779BC0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D-ABD1-4F74-A6E0-A76A6F779BC0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F-ABD1-4F74-A6E0-A76A6F779BC0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1-ABD1-4F74-A6E0-A76A6F779BC0}"/>
              </c:ext>
            </c:extLst>
          </c:dPt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ABD1-4F74-A6E0-A76A6F779BC0}"/>
                </c:ext>
              </c:extLst>
            </c:dLbl>
            <c:dLbl>
              <c:idx val="1"/>
              <c:layout>
                <c:manualLayout>
                  <c:x val="-0.270061576504326"/>
                  <c:y val="-0.152256827561982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zh-CN" sz="800" b="0" i="0" u="none" strike="noStrike" kern="1200" baseline="0">
                      <a:solidFill>
                        <a:schemeClr val="bg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separator>
</c:separator>
              <c:extLst>
                <c:ext xmlns:c15="http://schemas.microsoft.com/office/drawing/2012/chart" uri="{CE6537A1-D6FC-4f65-9D91-7224C49458BB}">
                  <c15:layout>
                    <c:manualLayout>
                      <c:w val="0.29417438271604901"/>
                      <c:h val="0.15799256505576201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3-ABD1-4F74-A6E0-A76A6F779BC0}"/>
                </c:ext>
              </c:extLst>
            </c:dLbl>
            <c:dLbl>
              <c:idx val="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ABD1-4F74-A6E0-A76A6F779BC0}"/>
                </c:ext>
              </c:extLst>
            </c:dLbl>
            <c:dLbl>
              <c:idx val="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ABD1-4F74-A6E0-A76A6F779BC0}"/>
                </c:ext>
              </c:extLst>
            </c:dLbl>
            <c:dLbl>
              <c:idx val="4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zh-CN" sz="800" b="0" i="0" u="none" strike="noStrike" kern="1200" baseline="0">
                      <a:solidFill>
                        <a:schemeClr val="bg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separator>
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ABD1-4F74-A6E0-A76A6F779BC0}"/>
                </c:ext>
              </c:extLst>
            </c:dLbl>
            <c:dLbl>
              <c:idx val="5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ABD1-4F74-A6E0-A76A6F779BC0}"/>
                </c:ext>
              </c:extLst>
            </c:dLbl>
            <c:dLbl>
              <c:idx val="6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ABD1-4F74-A6E0-A76A6F779BC0}"/>
                </c:ext>
              </c:extLst>
            </c:dLbl>
            <c:dLbl>
              <c:idx val="7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F-ABD1-4F74-A6E0-A76A6F779BC0}"/>
                </c:ext>
              </c:extLst>
            </c:dLbl>
            <c:dLbl>
              <c:idx val="8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1-ABD1-4F74-A6E0-A76A6F779BC0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zh-CN" sz="8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bestFit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prstDash val="solid"/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level-2'!$D$3:$L$3</c:f>
              <c:strCache>
                <c:ptCount val="9"/>
                <c:pt idx="0">
                  <c:v>Actinobacteria</c:v>
                </c:pt>
                <c:pt idx="1">
                  <c:v>Bacteroidetes</c:v>
                </c:pt>
                <c:pt idx="2">
                  <c:v>Cyanobacteria</c:v>
                </c:pt>
                <c:pt idx="3">
                  <c:v>Deferribacteres</c:v>
                </c:pt>
                <c:pt idx="4">
                  <c:v>Firmicutes</c:v>
                </c:pt>
                <c:pt idx="5">
                  <c:v>Patescibacteria</c:v>
                </c:pt>
                <c:pt idx="6">
                  <c:v>Proteobacteria</c:v>
                </c:pt>
                <c:pt idx="7">
                  <c:v>Tenericutes</c:v>
                </c:pt>
                <c:pt idx="8">
                  <c:v>Others</c:v>
                </c:pt>
              </c:strCache>
            </c:strRef>
          </c:cat>
          <c:val>
            <c:numRef>
              <c:f>'level-2'!$D$33:$L$33</c:f>
              <c:numCache>
                <c:formatCode>General</c:formatCode>
                <c:ptCount val="9"/>
                <c:pt idx="0">
                  <c:v>1.3815789473684199E-4</c:v>
                </c:pt>
                <c:pt idx="1">
                  <c:v>0.65019736842105302</c:v>
                </c:pt>
                <c:pt idx="2">
                  <c:v>3.02631578947368E-4</c:v>
                </c:pt>
                <c:pt idx="3">
                  <c:v>1.77631578947368E-4</c:v>
                </c:pt>
                <c:pt idx="4">
                  <c:v>0.34241447368421102</c:v>
                </c:pt>
                <c:pt idx="5">
                  <c:v>2.1118421052631598E-3</c:v>
                </c:pt>
                <c:pt idx="6">
                  <c:v>2.4276315789473701E-3</c:v>
                </c:pt>
                <c:pt idx="7">
                  <c:v>2.14473684210526E-3</c:v>
                </c:pt>
                <c:pt idx="8">
                  <c:v>8.5526315789473707E-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ABD1-4F74-A6E0-A76A6F779BC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</c:pie3D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/>
      </a:pPr>
      <a:endParaRPr lang="en-US"/>
    </a:p>
  </c:tx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zh-CN"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CN" sz="1200" b="1" i="0" u="none" strike="noStrike" kern="100" spc="0" baseline="0" dirty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BR 50 mg/kg</a:t>
            </a:r>
            <a:endParaRPr lang="zh-CN" altLang="en-US" sz="1200" b="1" i="0" u="none" strike="noStrike" kern="100" spc="0" baseline="0" dirty="0">
              <a:solidFill>
                <a:schemeClr val="tx1"/>
              </a:solidFill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20921358427089901"/>
          <c:y val="0.10129788917532399"/>
        </c:manualLayout>
      </c:layout>
      <c:overlay val="0"/>
      <c:spPr>
        <a:noFill/>
        <a:ln>
          <a:noFill/>
        </a:ln>
        <a:effectLst/>
      </c:spPr>
    </c:title>
    <c:autoTitleDeleted val="0"/>
    <c:view3D>
      <c:rotX val="30"/>
      <c:rotY val="0"/>
      <c:depthPercent val="100"/>
      <c:rAngAx val="0"/>
    </c:view3D>
    <c:floor>
      <c:thickness val="0"/>
      <c:spPr>
        <a:noFill/>
        <a:ln>
          <a:noFill/>
        </a:ln>
        <a:effectLst/>
      </c:spPr>
    </c:floor>
    <c:sideWall>
      <c:thickness val="0"/>
      <c:spPr>
        <a:noFill/>
        <a:ln>
          <a:noFill/>
        </a:ln>
        <a:effectLst/>
      </c:spPr>
    </c:sideWall>
    <c:backWall>
      <c:thickness val="0"/>
      <c:spPr>
        <a:noFill/>
        <a:ln>
          <a:noFill/>
        </a:ln>
        <a:effectLst/>
      </c:spPr>
    </c:backWall>
    <c:plotArea>
      <c:layout/>
      <c:pie3D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1-2FBF-4F7A-AC85-11D6F437C7CA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3-2FBF-4F7A-AC85-11D6F437C7CA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5-2FBF-4F7A-AC85-11D6F437C7CA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7-2FBF-4F7A-AC85-11D6F437C7CA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9-2FBF-4F7A-AC85-11D6F437C7CA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B-2FBF-4F7A-AC85-11D6F437C7CA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D-2FBF-4F7A-AC85-11D6F437C7CA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F-2FBF-4F7A-AC85-11D6F437C7CA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1-2FBF-4F7A-AC85-11D6F437C7CA}"/>
              </c:ext>
            </c:extLst>
          </c:dPt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2FBF-4F7A-AC85-11D6F437C7CA}"/>
                </c:ext>
              </c:extLst>
            </c:dLbl>
            <c:dLbl>
              <c:idx val="1"/>
              <c:layout>
                <c:manualLayout>
                  <c:x val="-0.297067901234568"/>
                  <c:y val="-0.168507352008508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zh-CN" sz="800" b="0" i="0" u="none" strike="noStrike" kern="1200" baseline="0">
                      <a:solidFill>
                        <a:schemeClr val="bg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separator>
</c:separator>
              <c:extLst>
                <c:ext xmlns:c15="http://schemas.microsoft.com/office/drawing/2012/chart" uri="{CE6537A1-D6FC-4f65-9D91-7224C49458BB}">
                  <c15:layout>
                    <c:manualLayout>
                      <c:w val="0.327932098765432"/>
                      <c:h val="0.15799256505576201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3-2FBF-4F7A-AC85-11D6F437C7CA}"/>
                </c:ext>
              </c:extLst>
            </c:dLbl>
            <c:dLbl>
              <c:idx val="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2FBF-4F7A-AC85-11D6F437C7CA}"/>
                </c:ext>
              </c:extLst>
            </c:dLbl>
            <c:dLbl>
              <c:idx val="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2FBF-4F7A-AC85-11D6F437C7CA}"/>
                </c:ext>
              </c:extLst>
            </c:dLbl>
            <c:dLbl>
              <c:idx val="4"/>
              <c:layout>
                <c:manualLayout>
                  <c:x val="0.195560233790221"/>
                  <c:y val="6.9542585057908696E-2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zh-CN" sz="800" b="0" i="0" u="none" strike="noStrike" kern="1200" baseline="0">
                      <a:solidFill>
                        <a:schemeClr val="bg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separator>
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2FBF-4F7A-AC85-11D6F437C7CA}"/>
                </c:ext>
              </c:extLst>
            </c:dLbl>
            <c:dLbl>
              <c:idx val="5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2FBF-4F7A-AC85-11D6F437C7CA}"/>
                </c:ext>
              </c:extLst>
            </c:dLbl>
            <c:dLbl>
              <c:idx val="6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2FBF-4F7A-AC85-11D6F437C7CA}"/>
                </c:ext>
              </c:extLst>
            </c:dLbl>
            <c:dLbl>
              <c:idx val="7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F-2FBF-4F7A-AC85-11D6F437C7CA}"/>
                </c:ext>
              </c:extLst>
            </c:dLbl>
            <c:dLbl>
              <c:idx val="8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1-2FBF-4F7A-AC85-11D6F437C7C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zh-CN" sz="8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bestFit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prstDash val="solid"/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level-2'!$D$3:$L$3</c:f>
              <c:strCache>
                <c:ptCount val="9"/>
                <c:pt idx="0">
                  <c:v>Actinobacteria</c:v>
                </c:pt>
                <c:pt idx="1">
                  <c:v>Bacteroidetes</c:v>
                </c:pt>
                <c:pt idx="2">
                  <c:v>Cyanobacteria</c:v>
                </c:pt>
                <c:pt idx="3">
                  <c:v>Deferribacteres</c:v>
                </c:pt>
                <c:pt idx="4">
                  <c:v>Firmicutes</c:v>
                </c:pt>
                <c:pt idx="5">
                  <c:v>Patescibacteria</c:v>
                </c:pt>
                <c:pt idx="6">
                  <c:v>Proteobacteria</c:v>
                </c:pt>
                <c:pt idx="7">
                  <c:v>Tenericutes</c:v>
                </c:pt>
                <c:pt idx="8">
                  <c:v>Others</c:v>
                </c:pt>
              </c:strCache>
            </c:strRef>
          </c:cat>
          <c:val>
            <c:numRef>
              <c:f>'level-2'!$D$34:$L$34</c:f>
              <c:numCache>
                <c:formatCode>General</c:formatCode>
                <c:ptCount val="9"/>
                <c:pt idx="0">
                  <c:v>1.9736842105263201E-4</c:v>
                </c:pt>
                <c:pt idx="1">
                  <c:v>0.69323684210526304</c:v>
                </c:pt>
                <c:pt idx="2">
                  <c:v>8.2236842105263197E-4</c:v>
                </c:pt>
                <c:pt idx="3">
                  <c:v>5.7894736842105301E-4</c:v>
                </c:pt>
                <c:pt idx="4">
                  <c:v>0.295269736842105</c:v>
                </c:pt>
                <c:pt idx="5">
                  <c:v>2.6776315789473698E-3</c:v>
                </c:pt>
                <c:pt idx="6">
                  <c:v>5.3881578947368404E-3</c:v>
                </c:pt>
                <c:pt idx="7">
                  <c:v>1.82894736842105E-3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2FBF-4F7A-AC85-11D6F437C7C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</c:pie3D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/>
      </a:pPr>
      <a:endParaRPr lang="en-US"/>
    </a:p>
  </c:tx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en-US" altLang="zh-CN" sz="1200" b="1" i="0" u="none" strike="noStrike" kern="100" spc="0" baseline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defRPr>
            </a:pPr>
            <a:r>
              <a:rPr lang="en-US" altLang="zh-CN" sz="1200" b="1" i="0" u="none" strike="noStrike" kern="100" spc="0" baseline="0" dirty="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BR 100 mg/kg</a:t>
            </a:r>
          </a:p>
        </c:rich>
      </c:tx>
      <c:layout>
        <c:manualLayout>
          <c:xMode val="edge"/>
          <c:yMode val="edge"/>
          <c:x val="0.18054456561040899"/>
          <c:y val="9.4544696563635303E-2"/>
        </c:manualLayout>
      </c:layout>
      <c:overlay val="0"/>
      <c:spPr>
        <a:noFill/>
        <a:ln>
          <a:noFill/>
        </a:ln>
        <a:effectLst/>
      </c:spPr>
    </c:title>
    <c:autoTitleDeleted val="0"/>
    <c:view3D>
      <c:rotX val="30"/>
      <c:rotY val="0"/>
      <c:depthPercent val="100"/>
      <c:rAngAx val="0"/>
    </c:view3D>
    <c:floor>
      <c:thickness val="0"/>
      <c:spPr>
        <a:noFill/>
        <a:ln>
          <a:noFill/>
        </a:ln>
        <a:effectLst/>
      </c:spPr>
    </c:floor>
    <c:sideWall>
      <c:thickness val="0"/>
      <c:spPr>
        <a:noFill/>
        <a:ln>
          <a:noFill/>
        </a:ln>
        <a:effectLst/>
      </c:spPr>
    </c:sideWall>
    <c:backWall>
      <c:thickness val="0"/>
      <c:spPr>
        <a:noFill/>
        <a:ln>
          <a:noFill/>
        </a:ln>
        <a:effectLst/>
      </c:spPr>
    </c:backWall>
    <c:plotArea>
      <c:layout/>
      <c:pie3D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1-77AB-4BCB-B27D-D4B4902EC76C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3-77AB-4BCB-B27D-D4B4902EC76C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5-77AB-4BCB-B27D-D4B4902EC76C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7-77AB-4BCB-B27D-D4B4902EC76C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9-77AB-4BCB-B27D-D4B4902EC76C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B-77AB-4BCB-B27D-D4B4902EC76C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D-77AB-4BCB-B27D-D4B4902EC76C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F-77AB-4BCB-B27D-D4B4902EC76C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1-77AB-4BCB-B27D-D4B4902EC76C}"/>
              </c:ext>
            </c:extLst>
          </c:dPt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77AB-4BCB-B27D-D4B4902EC76C}"/>
                </c:ext>
              </c:extLst>
            </c:dLbl>
            <c:dLbl>
              <c:idx val="1"/>
              <c:layout>
                <c:manualLayout>
                  <c:x val="-0.25940871974336499"/>
                  <c:y val="-0.16747699753144199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zh-CN" sz="800" b="0" i="0" u="none" strike="noStrike" kern="1200" baseline="0">
                      <a:solidFill>
                        <a:schemeClr val="bg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separator>
</c:separator>
              <c:extLst>
                <c:ext xmlns:c15="http://schemas.microsoft.com/office/drawing/2012/chart" uri="{CE6537A1-D6FC-4f65-9D91-7224C49458BB}">
                  <c15:layout>
                    <c:manualLayout>
                      <c:w val="0.26111111111111102"/>
                      <c:h val="0.22276976065724099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3-77AB-4BCB-B27D-D4B4902EC76C}"/>
                </c:ext>
              </c:extLst>
            </c:dLbl>
            <c:dLbl>
              <c:idx val="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77AB-4BCB-B27D-D4B4902EC76C}"/>
                </c:ext>
              </c:extLst>
            </c:dLbl>
            <c:dLbl>
              <c:idx val="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77AB-4BCB-B27D-D4B4902EC76C}"/>
                </c:ext>
              </c:extLst>
            </c:dLbl>
            <c:dLbl>
              <c:idx val="4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zh-CN" sz="800" b="0" i="0" u="none" strike="noStrike" kern="1200" baseline="0">
                      <a:solidFill>
                        <a:schemeClr val="bg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separator>
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77AB-4BCB-B27D-D4B4902EC76C}"/>
                </c:ext>
              </c:extLst>
            </c:dLbl>
            <c:dLbl>
              <c:idx val="5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77AB-4BCB-B27D-D4B4902EC76C}"/>
                </c:ext>
              </c:extLst>
            </c:dLbl>
            <c:dLbl>
              <c:idx val="6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77AB-4BCB-B27D-D4B4902EC76C}"/>
                </c:ext>
              </c:extLst>
            </c:dLbl>
            <c:dLbl>
              <c:idx val="7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F-77AB-4BCB-B27D-D4B4902EC76C}"/>
                </c:ext>
              </c:extLst>
            </c:dLbl>
            <c:dLbl>
              <c:idx val="8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1-77AB-4BCB-B27D-D4B4902EC76C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zh-CN" sz="8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bestFit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prstDash val="solid"/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level-2'!$D$3:$L$3</c:f>
              <c:strCache>
                <c:ptCount val="9"/>
                <c:pt idx="0">
                  <c:v>Actinobacteria</c:v>
                </c:pt>
                <c:pt idx="1">
                  <c:v>Bacteroidetes</c:v>
                </c:pt>
                <c:pt idx="2">
                  <c:v>Cyanobacteria</c:v>
                </c:pt>
                <c:pt idx="3">
                  <c:v>Deferribacteres</c:v>
                </c:pt>
                <c:pt idx="4">
                  <c:v>Firmicutes</c:v>
                </c:pt>
                <c:pt idx="5">
                  <c:v>Patescibacteria</c:v>
                </c:pt>
                <c:pt idx="6">
                  <c:v>Proteobacteria</c:v>
                </c:pt>
                <c:pt idx="7">
                  <c:v>Tenericutes</c:v>
                </c:pt>
                <c:pt idx="8">
                  <c:v>Others</c:v>
                </c:pt>
              </c:strCache>
            </c:strRef>
          </c:cat>
          <c:val>
            <c:numRef>
              <c:f>'level-2'!$D$35:$L$35</c:f>
              <c:numCache>
                <c:formatCode>General</c:formatCode>
                <c:ptCount val="9"/>
                <c:pt idx="0">
                  <c:v>2.7067669172932299E-4</c:v>
                </c:pt>
                <c:pt idx="1">
                  <c:v>0.67651127819548895</c:v>
                </c:pt>
                <c:pt idx="2">
                  <c:v>3.9097744360902298E-4</c:v>
                </c:pt>
                <c:pt idx="3">
                  <c:v>6.9172932330827097E-4</c:v>
                </c:pt>
                <c:pt idx="4">
                  <c:v>0.31443609022556401</c:v>
                </c:pt>
                <c:pt idx="5">
                  <c:v>1.3308270676691701E-3</c:v>
                </c:pt>
                <c:pt idx="6">
                  <c:v>5.2180451127819497E-3</c:v>
                </c:pt>
                <c:pt idx="7">
                  <c:v>1.0601503759398499E-3</c:v>
                </c:pt>
                <c:pt idx="8">
                  <c:v>9.0225563909774396E-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77AB-4BCB-B27D-D4B4902EC76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</c:pie3D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en-US" sz="1200" b="1" i="0" u="none" strike="noStrike" kern="1200" spc="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b="1" i="0" u="none" strike="noStrike" kern="1200" spc="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BR</a:t>
            </a:r>
          </a:p>
        </c:rich>
      </c:tx>
      <c:layout>
        <c:manualLayout>
          <c:xMode val="edge"/>
          <c:yMode val="edge"/>
          <c:x val="0.43551222222222202"/>
          <c:y val="0.117742132368734"/>
        </c:manualLayout>
      </c:layout>
      <c:overlay val="0"/>
      <c:spPr>
        <a:noFill/>
        <a:ln>
          <a:noFill/>
        </a:ln>
        <a:effectLst/>
      </c:spPr>
    </c:title>
    <c:autoTitleDeleted val="0"/>
    <c:view3D>
      <c:rotX val="30"/>
      <c:rotY val="0"/>
      <c:depthPercent val="100"/>
      <c:rAngAx val="0"/>
    </c:view3D>
    <c:floor>
      <c:thickness val="0"/>
      <c:spPr>
        <a:noFill/>
        <a:ln>
          <a:noFill/>
        </a:ln>
        <a:effectLst/>
      </c:spPr>
    </c:floor>
    <c:sideWall>
      <c:thickness val="0"/>
      <c:spPr>
        <a:noFill/>
        <a:ln>
          <a:noFill/>
        </a:ln>
        <a:effectLst/>
      </c:spPr>
    </c:sideWall>
    <c:backWall>
      <c:thickness val="0"/>
      <c:spPr>
        <a:noFill/>
        <a:ln>
          <a:noFill/>
        </a:ln>
        <a:effectLst/>
      </c:spPr>
    </c:backWall>
    <c:plotArea>
      <c:layout/>
      <c:pie3D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1-D301-4D09-8CD6-D7994895FB0A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3-D301-4D09-8CD6-D7994895FB0A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5-D301-4D09-8CD6-D7994895FB0A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7-D301-4D09-8CD6-D7994895FB0A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9-D301-4D09-8CD6-D7994895FB0A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B-D301-4D09-8CD6-D7994895FB0A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D-D301-4D09-8CD6-D7994895FB0A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F-D301-4D09-8CD6-D7994895FB0A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1-D301-4D09-8CD6-D7994895FB0A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3-D301-4D09-8CD6-D7994895FB0A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5-D301-4D09-8CD6-D7994895FB0A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7-D301-4D09-8CD6-D7994895FB0A}"/>
              </c:ext>
            </c:extLst>
          </c:dPt>
          <c:dPt>
            <c:idx val="12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9-D301-4D09-8CD6-D7994895FB0A}"/>
              </c:ext>
            </c:extLst>
          </c:dPt>
          <c:dPt>
            <c:idx val="13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B-D301-4D09-8CD6-D7994895FB0A}"/>
              </c:ext>
            </c:extLst>
          </c:dPt>
          <c:dPt>
            <c:idx val="14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D-D301-4D09-8CD6-D7994895FB0A}"/>
              </c:ext>
            </c:extLst>
          </c:dPt>
          <c:dPt>
            <c:idx val="15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F-D301-4D09-8CD6-D7994895FB0A}"/>
              </c:ext>
            </c:extLst>
          </c:dPt>
          <c:dLbls>
            <c:dLbl>
              <c:idx val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zh-CN" sz="900" b="0" i="0" u="none" strike="noStrike" kern="1200" baseline="0">
                      <a:solidFill>
                        <a:schemeClr val="bg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separator>
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D301-4D09-8CD6-D7994895FB0A}"/>
                </c:ext>
              </c:extLst>
            </c:dLbl>
            <c:dLbl>
              <c:idx val="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D301-4D09-8CD6-D7994895FB0A}"/>
                </c:ext>
              </c:extLst>
            </c:dLbl>
            <c:dLbl>
              <c:idx val="2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zh-CN" sz="900" b="0" i="0" u="none" strike="noStrike" kern="1200" baseline="0">
                      <a:solidFill>
                        <a:schemeClr val="bg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separator>
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D301-4D09-8CD6-D7994895FB0A}"/>
                </c:ext>
              </c:extLst>
            </c:dLbl>
            <c:dLbl>
              <c:idx val="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D301-4D09-8CD6-D7994895FB0A}"/>
                </c:ext>
              </c:extLst>
            </c:dLbl>
            <c:dLbl>
              <c:idx val="4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D301-4D09-8CD6-D7994895FB0A}"/>
                </c:ext>
              </c:extLst>
            </c:dLbl>
            <c:dLbl>
              <c:idx val="5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D301-4D09-8CD6-D7994895FB0A}"/>
                </c:ext>
              </c:extLst>
            </c:dLbl>
            <c:dLbl>
              <c:idx val="6"/>
              <c:layout>
                <c:manualLayout>
                  <c:x val="-5.2171805555555603E-2"/>
                  <c:y val="-0.15178639949606801"/>
                </c:manualLayout>
              </c:layout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separator>
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D301-4D09-8CD6-D7994895FB0A}"/>
                </c:ext>
              </c:extLst>
            </c:dLbl>
            <c:dLbl>
              <c:idx val="7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F-D301-4D09-8CD6-D7994895FB0A}"/>
                </c:ext>
              </c:extLst>
            </c:dLbl>
            <c:dLbl>
              <c:idx val="8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1-D301-4D09-8CD6-D7994895FB0A}"/>
                </c:ext>
              </c:extLst>
            </c:dLbl>
            <c:dLbl>
              <c:idx val="9"/>
              <c:layout>
                <c:manualLayout>
                  <c:x val="-6.9414722222222294E-2"/>
                  <c:y val="-2.0044490662266001E-2"/>
                </c:manualLayout>
              </c:layout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separator>
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3-D301-4D09-8CD6-D7994895FB0A}"/>
                </c:ext>
              </c:extLst>
            </c:dLbl>
            <c:dLbl>
              <c:idx val="1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5-D301-4D09-8CD6-D7994895FB0A}"/>
                </c:ext>
              </c:extLst>
            </c:dLbl>
            <c:dLbl>
              <c:idx val="1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7-D301-4D09-8CD6-D7994895FB0A}"/>
                </c:ext>
              </c:extLst>
            </c:dLbl>
            <c:dLbl>
              <c:idx val="1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9-D301-4D09-8CD6-D7994895FB0A}"/>
                </c:ext>
              </c:extLst>
            </c:dLbl>
            <c:dLbl>
              <c:idx val="1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B-D301-4D09-8CD6-D7994895FB0A}"/>
                </c:ext>
              </c:extLst>
            </c:dLbl>
            <c:dLbl>
              <c:idx val="14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D-D301-4D09-8CD6-D7994895FB0A}"/>
                </c:ext>
              </c:extLst>
            </c:dLbl>
            <c:dLbl>
              <c:idx val="15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F-D301-4D09-8CD6-D7994895FB0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zh-CN"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bestFit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prstDash val="solid"/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Fecl-C-final'!$F$1:$U$1</c:f>
              <c:strCache>
                <c:ptCount val="16"/>
                <c:pt idx="0">
                  <c:v>TβMCA</c:v>
                </c:pt>
                <c:pt idx="1">
                  <c:v>GβMCA</c:v>
                </c:pt>
                <c:pt idx="2">
                  <c:v>TCA</c:v>
                </c:pt>
                <c:pt idx="3">
                  <c:v>GCA</c:v>
                </c:pt>
                <c:pt idx="4">
                  <c:v>TCDCA</c:v>
                </c:pt>
                <c:pt idx="5">
                  <c:v>TUDCA</c:v>
                </c:pt>
                <c:pt idx="6">
                  <c:v>βMCA</c:v>
                </c:pt>
                <c:pt idx="7">
                  <c:v>CA</c:v>
                </c:pt>
                <c:pt idx="8">
                  <c:v>CDCA</c:v>
                </c:pt>
                <c:pt idx="9">
                  <c:v>TωMCA</c:v>
                </c:pt>
                <c:pt idx="10">
                  <c:v>THDCA</c:v>
                </c:pt>
                <c:pt idx="11">
                  <c:v>TDCA</c:v>
                </c:pt>
                <c:pt idx="12">
                  <c:v>TLCA</c:v>
                </c:pt>
                <c:pt idx="13">
                  <c:v>GLCA</c:v>
                </c:pt>
                <c:pt idx="14">
                  <c:v>7keto_DCA</c:v>
                </c:pt>
                <c:pt idx="15">
                  <c:v>DCA</c:v>
                </c:pt>
              </c:strCache>
            </c:strRef>
          </c:cat>
          <c:val>
            <c:numRef>
              <c:f>'Fecl-C-final'!$F$28:$U$28</c:f>
              <c:numCache>
                <c:formatCode>0.00</c:formatCode>
                <c:ptCount val="16"/>
                <c:pt idx="0">
                  <c:v>0.319504437781369</c:v>
                </c:pt>
                <c:pt idx="1">
                  <c:v>2.1203981359645301E-4</c:v>
                </c:pt>
                <c:pt idx="2">
                  <c:v>0.29783290240393601</c:v>
                </c:pt>
                <c:pt idx="3">
                  <c:v>4.9809093598518896E-4</c:v>
                </c:pt>
                <c:pt idx="4">
                  <c:v>2.4217703399918101E-3</c:v>
                </c:pt>
                <c:pt idx="5">
                  <c:v>4.0349467370664497E-3</c:v>
                </c:pt>
                <c:pt idx="6">
                  <c:v>6.17356431409221E-2</c:v>
                </c:pt>
                <c:pt idx="7">
                  <c:v>0.121694027134917</c:v>
                </c:pt>
                <c:pt idx="8">
                  <c:v>1.5971899863993701E-4</c:v>
                </c:pt>
                <c:pt idx="9">
                  <c:v>0.18749603692230901</c:v>
                </c:pt>
                <c:pt idx="10">
                  <c:v>2.9075933023899499E-3</c:v>
                </c:pt>
                <c:pt idx="11">
                  <c:v>1.68517353854489E-3</c:v>
                </c:pt>
                <c:pt idx="12">
                  <c:v>4.0803650759998699E-5</c:v>
                </c:pt>
                <c:pt idx="13">
                  <c:v>6.1087846833616705E-5</c:v>
                </c:pt>
                <c:pt idx="14">
                  <c:v>3.2049378389369001E-4</c:v>
                </c:pt>
                <c:pt idx="15">
                  <c:v>1.7113050077960601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0-D301-4D09-8CD6-D7994895FB0A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  <c:showLeaderLines val="1"/>
        </c:dLbls>
      </c:pie3D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view3D>
      <c:rotX val="30"/>
      <c:rotY val="0"/>
      <c:depthPercent val="100"/>
      <c:rAngAx val="0"/>
    </c:view3D>
    <c:floor>
      <c:thickness val="0"/>
      <c:spPr>
        <a:noFill/>
        <a:ln>
          <a:noFill/>
        </a:ln>
        <a:effectLst/>
      </c:spPr>
    </c:floor>
    <c:sideWall>
      <c:thickness val="0"/>
      <c:spPr>
        <a:noFill/>
        <a:ln>
          <a:noFill/>
        </a:ln>
        <a:effectLst/>
      </c:spPr>
    </c:sideWall>
    <c:backWall>
      <c:thickness val="0"/>
      <c:spPr>
        <a:noFill/>
        <a:ln>
          <a:noFill/>
        </a:ln>
        <a:effectLst/>
      </c:spPr>
    </c:backWall>
    <c:plotArea>
      <c:layout>
        <c:manualLayout>
          <c:layoutTarget val="inner"/>
          <c:xMode val="edge"/>
          <c:yMode val="edge"/>
          <c:x val="0"/>
          <c:y val="0.59561413002446095"/>
          <c:w val="3.6111111111111101E-2"/>
          <c:h val="1.5663290031021598E-2"/>
        </c:manualLayout>
      </c:layout>
      <c:pie3D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1-9598-46BC-9590-98A7F34B078E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3-9598-46BC-9590-98A7F34B078E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5-9598-46BC-9590-98A7F34B078E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7-9598-46BC-9590-98A7F34B078E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9-9598-46BC-9590-98A7F34B078E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B-9598-46BC-9590-98A7F34B078E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D-9598-46BC-9590-98A7F34B078E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F-9598-46BC-9590-98A7F34B078E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1-9598-46BC-9590-98A7F34B078E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3-9598-46BC-9590-98A7F34B078E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5-9598-46BC-9590-98A7F34B078E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7-9598-46BC-9590-98A7F34B078E}"/>
              </c:ext>
            </c:extLst>
          </c:dPt>
          <c:dPt>
            <c:idx val="12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9-9598-46BC-9590-98A7F34B078E}"/>
              </c:ext>
            </c:extLst>
          </c:dPt>
          <c:dPt>
            <c:idx val="13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B-9598-46BC-9590-98A7F34B078E}"/>
              </c:ext>
            </c:extLst>
          </c:dPt>
          <c:dPt>
            <c:idx val="14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D-9598-46BC-9590-98A7F34B078E}"/>
              </c:ext>
            </c:extLst>
          </c:dPt>
          <c:dPt>
            <c:idx val="15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F-9598-46BC-9590-98A7F34B078E}"/>
              </c:ext>
            </c:extLst>
          </c:dPt>
          <c:cat>
            <c:strRef>
              <c:f>'Fecl-C-final'!$F$1:$U$1</c:f>
              <c:strCache>
                <c:ptCount val="16"/>
                <c:pt idx="0">
                  <c:v>TβMCA</c:v>
                </c:pt>
                <c:pt idx="1">
                  <c:v>GβMCA</c:v>
                </c:pt>
                <c:pt idx="2">
                  <c:v>TCA</c:v>
                </c:pt>
                <c:pt idx="3">
                  <c:v>GCA</c:v>
                </c:pt>
                <c:pt idx="4">
                  <c:v>TCDCA</c:v>
                </c:pt>
                <c:pt idx="5">
                  <c:v>TUDCA</c:v>
                </c:pt>
                <c:pt idx="6">
                  <c:v>βMCA</c:v>
                </c:pt>
                <c:pt idx="7">
                  <c:v>CA</c:v>
                </c:pt>
                <c:pt idx="8">
                  <c:v>CDCA</c:v>
                </c:pt>
                <c:pt idx="9">
                  <c:v>TωMCA</c:v>
                </c:pt>
                <c:pt idx="10">
                  <c:v>THDCA</c:v>
                </c:pt>
                <c:pt idx="11">
                  <c:v>TDCA</c:v>
                </c:pt>
                <c:pt idx="12">
                  <c:v>TLCA</c:v>
                </c:pt>
                <c:pt idx="13">
                  <c:v>GLCA</c:v>
                </c:pt>
                <c:pt idx="14">
                  <c:v>7keto_DCA</c:v>
                </c:pt>
                <c:pt idx="15">
                  <c:v>DCA</c:v>
                </c:pt>
              </c:strCache>
            </c:strRef>
          </c:cat>
          <c:val>
            <c:numRef>
              <c:f>'Fecl-C-final'!$F$26:$U$26</c:f>
              <c:numCache>
                <c:formatCode>0.00</c:formatCode>
                <c:ptCount val="16"/>
                <c:pt idx="0">
                  <c:v>0.32577784158456802</c:v>
                </c:pt>
                <c:pt idx="1">
                  <c:v>1.5265615270842301E-4</c:v>
                </c:pt>
                <c:pt idx="2">
                  <c:v>0.37061277185742197</c:v>
                </c:pt>
                <c:pt idx="3">
                  <c:v>3.1548292412538501E-4</c:v>
                </c:pt>
                <c:pt idx="4">
                  <c:v>2.2092347476645401E-3</c:v>
                </c:pt>
                <c:pt idx="5">
                  <c:v>3.0519311476898598E-3</c:v>
                </c:pt>
                <c:pt idx="6">
                  <c:v>5.4559167658720098E-2</c:v>
                </c:pt>
                <c:pt idx="7">
                  <c:v>8.7960898863485598E-2</c:v>
                </c:pt>
                <c:pt idx="8">
                  <c:v>1.5025571954138201E-4</c:v>
                </c:pt>
                <c:pt idx="9">
                  <c:v>0.149369538214222</c:v>
                </c:pt>
                <c:pt idx="10">
                  <c:v>3.24403465620821E-3</c:v>
                </c:pt>
                <c:pt idx="11">
                  <c:v>2.0558786466894101E-3</c:v>
                </c:pt>
                <c:pt idx="12">
                  <c:v>2.1337500282449801E-5</c:v>
                </c:pt>
                <c:pt idx="13">
                  <c:v>2.1188393256841399E-5</c:v>
                </c:pt>
                <c:pt idx="14">
                  <c:v>2.7714104970276801E-4</c:v>
                </c:pt>
                <c:pt idx="15">
                  <c:v>2.3653217865513701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0-9598-46BC-9590-98A7F34B078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</c:pie3DChart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2.46097987751531E-2"/>
          <c:y val="0.364310781671494"/>
          <c:w val="0.97539020122484699"/>
          <c:h val="0.5708733115426489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zh-CN"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en-US" altLang="zh-CN" sz="1200" b="1" i="0" u="none" strike="noStrike" kern="1200" spc="0" baseline="0" dirty="0" smtClean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CN" sz="1200" b="1" i="0" u="none" strike="noStrike" kern="1200" spc="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 Control</a:t>
            </a:r>
          </a:p>
        </c:rich>
      </c:tx>
      <c:layout>
        <c:manualLayout>
          <c:xMode val="edge"/>
          <c:yMode val="edge"/>
          <c:x val="0.39247453019425699"/>
          <c:y val="9.0994896643171994E-2"/>
        </c:manualLayout>
      </c:layout>
      <c:overlay val="0"/>
      <c:spPr>
        <a:noFill/>
        <a:ln>
          <a:noFill/>
        </a:ln>
        <a:effectLst/>
      </c:spPr>
    </c:title>
    <c:autoTitleDeleted val="0"/>
    <c:view3D>
      <c:rotX val="30"/>
      <c:rotY val="0"/>
      <c:depthPercent val="100"/>
      <c:rAngAx val="0"/>
    </c:view3D>
    <c:floor>
      <c:thickness val="0"/>
      <c:spPr>
        <a:noFill/>
        <a:ln>
          <a:noFill/>
        </a:ln>
        <a:effectLst/>
      </c:spPr>
    </c:floor>
    <c:sideWall>
      <c:thickness val="0"/>
      <c:spPr>
        <a:noFill/>
        <a:ln>
          <a:noFill/>
        </a:ln>
        <a:effectLst/>
      </c:spPr>
    </c:sideWall>
    <c:backWall>
      <c:thickness val="0"/>
      <c:spPr>
        <a:noFill/>
        <a:ln>
          <a:noFill/>
        </a:ln>
        <a:effectLst/>
      </c:spPr>
    </c:backWall>
    <c:plotArea>
      <c:layout/>
      <c:pie3D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1-BACB-47AC-8D77-F84EF2FBB904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3-BACB-47AC-8D77-F84EF2FBB904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5-BACB-47AC-8D77-F84EF2FBB904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7-BACB-47AC-8D77-F84EF2FBB904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9-BACB-47AC-8D77-F84EF2FBB904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B-BACB-47AC-8D77-F84EF2FBB904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D-BACB-47AC-8D77-F84EF2FBB904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F-BACB-47AC-8D77-F84EF2FBB904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1-BACB-47AC-8D77-F84EF2FBB904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3-BACB-47AC-8D77-F84EF2FBB904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5-BACB-47AC-8D77-F84EF2FBB904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7-BACB-47AC-8D77-F84EF2FBB904}"/>
              </c:ext>
            </c:extLst>
          </c:dPt>
          <c:dPt>
            <c:idx val="12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9-BACB-47AC-8D77-F84EF2FBB904}"/>
              </c:ext>
            </c:extLst>
          </c:dPt>
          <c:dLbls>
            <c:dLbl>
              <c:idx val="0"/>
              <c:layout>
                <c:manualLayout>
                  <c:x val="5.9586527777777801E-2"/>
                  <c:y val="6.8444650587507705E-2"/>
                </c:manualLayout>
              </c:layout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separator>
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BACB-47AC-8D77-F84EF2FBB904}"/>
                </c:ext>
              </c:extLst>
            </c:dLbl>
            <c:dLbl>
              <c:idx val="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BACB-47AC-8D77-F84EF2FBB904}"/>
                </c:ext>
              </c:extLst>
            </c:dLbl>
            <c:dLbl>
              <c:idx val="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BACB-47AC-8D77-F84EF2FBB904}"/>
                </c:ext>
              </c:extLst>
            </c:dLbl>
            <c:dLbl>
              <c:idx val="3"/>
              <c:layout>
                <c:manualLayout>
                  <c:x val="-0.17373611111111101"/>
                  <c:y val="-0.22317986293379999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zh-CN" sz="900" b="0" i="0" u="none" strike="noStrike" kern="1200" baseline="0">
                      <a:solidFill>
                        <a:schemeClr val="bg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separator>
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BACB-47AC-8D77-F84EF2FBB904}"/>
                </c:ext>
              </c:extLst>
            </c:dLbl>
            <c:dLbl>
              <c:idx val="4"/>
              <c:layout>
                <c:manualLayout>
                  <c:x val="-6.3356944444444396E-2"/>
                  <c:y val="-3.4628427128427099E-2"/>
                </c:manualLayout>
              </c:layout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separator>
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BACB-47AC-8D77-F84EF2FBB904}"/>
                </c:ext>
              </c:extLst>
            </c:dLbl>
            <c:dLbl>
              <c:idx val="5"/>
              <c:layout>
                <c:manualLayout>
                  <c:x val="-5.6222777777777802E-2"/>
                  <c:y val="-8.5414347557204798E-2"/>
                </c:manualLayout>
              </c:layout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separator>
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BACB-47AC-8D77-F84EF2FBB904}"/>
                </c:ext>
              </c:extLst>
            </c:dLbl>
            <c:dLbl>
              <c:idx val="6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BACB-47AC-8D77-F84EF2FBB904}"/>
                </c:ext>
              </c:extLst>
            </c:dLbl>
            <c:dLbl>
              <c:idx val="7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F-BACB-47AC-8D77-F84EF2FBB904}"/>
                </c:ext>
              </c:extLst>
            </c:dLbl>
            <c:dLbl>
              <c:idx val="8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1-BACB-47AC-8D77-F84EF2FBB904}"/>
                </c:ext>
              </c:extLst>
            </c:dLbl>
            <c:dLbl>
              <c:idx val="9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3-BACB-47AC-8D77-F84EF2FBB904}"/>
                </c:ext>
              </c:extLst>
            </c:dLbl>
            <c:dLbl>
              <c:idx val="1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5-BACB-47AC-8D77-F84EF2FBB904}"/>
                </c:ext>
              </c:extLst>
            </c:dLbl>
            <c:dLbl>
              <c:idx val="11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zh-CN" sz="900" b="0" i="0" u="none" strike="noStrike" kern="1200" baseline="0">
                      <a:solidFill>
                        <a:schemeClr val="bg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separator>
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7-BACB-47AC-8D77-F84EF2FBB904}"/>
                </c:ext>
              </c:extLst>
            </c:dLbl>
            <c:dLbl>
              <c:idx val="1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9-BACB-47AC-8D77-F84EF2FBB90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zh-CN"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bestFit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prstDash val="solid"/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individuals-less'!$F$1:$R$1</c:f>
              <c:strCache>
                <c:ptCount val="13"/>
                <c:pt idx="0">
                  <c:v>TβMCA</c:v>
                </c:pt>
                <c:pt idx="1">
                  <c:v>TCA</c:v>
                </c:pt>
                <c:pt idx="2">
                  <c:v>GCA</c:v>
                </c:pt>
                <c:pt idx="3">
                  <c:v>βMCA</c:v>
                </c:pt>
                <c:pt idx="4">
                  <c:v>CA</c:v>
                </c:pt>
                <c:pt idx="5">
                  <c:v>CDCA</c:v>
                </c:pt>
                <c:pt idx="6">
                  <c:v>TωMCA</c:v>
                </c:pt>
                <c:pt idx="7">
                  <c:v>TLCA</c:v>
                </c:pt>
                <c:pt idx="8">
                  <c:v>GLCA</c:v>
                </c:pt>
                <c:pt idx="9">
                  <c:v>isoDCA</c:v>
                </c:pt>
                <c:pt idx="10">
                  <c:v>12keto_LCA</c:v>
                </c:pt>
                <c:pt idx="11">
                  <c:v>DCA</c:v>
                </c:pt>
                <c:pt idx="12">
                  <c:v>LCA</c:v>
                </c:pt>
              </c:strCache>
            </c:strRef>
          </c:cat>
          <c:val>
            <c:numRef>
              <c:f>'individuals-less'!$F$25:$R$25</c:f>
              <c:numCache>
                <c:formatCode>0.00</c:formatCode>
                <c:ptCount val="13"/>
                <c:pt idx="0">
                  <c:v>0.137834497587705</c:v>
                </c:pt>
                <c:pt idx="1">
                  <c:v>8.0788784569886904E-2</c:v>
                </c:pt>
                <c:pt idx="2">
                  <c:v>1.65159049259554E-3</c:v>
                </c:pt>
                <c:pt idx="3">
                  <c:v>0.36426148184910101</c:v>
                </c:pt>
                <c:pt idx="4">
                  <c:v>7.5030039799384496E-2</c:v>
                </c:pt>
                <c:pt idx="5">
                  <c:v>9.7114446365514806E-2</c:v>
                </c:pt>
                <c:pt idx="6">
                  <c:v>3.6024124022299701E-2</c:v>
                </c:pt>
                <c:pt idx="7">
                  <c:v>1.50940389533037E-3</c:v>
                </c:pt>
                <c:pt idx="8">
                  <c:v>1.4184895099198301E-3</c:v>
                </c:pt>
                <c:pt idx="9">
                  <c:v>9.4388390399126505E-3</c:v>
                </c:pt>
                <c:pt idx="10">
                  <c:v>1.48120918097733E-2</c:v>
                </c:pt>
                <c:pt idx="11">
                  <c:v>0.196540947917794</c:v>
                </c:pt>
                <c:pt idx="12">
                  <c:v>1.10245885092363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A-BACB-47AC-8D77-F84EF2FBB9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</c:pie3D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/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en-US" altLang="zh-CN" sz="1200" b="1" i="0" u="none" strike="noStrike" kern="1200" spc="0" baseline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CN" sz="1200" b="1" i="0" u="none" strike="noStrike" kern="1200" spc="0" baseline="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  BBR</a:t>
            </a:r>
          </a:p>
        </c:rich>
      </c:tx>
      <c:layout>
        <c:manualLayout>
          <c:xMode val="edge"/>
          <c:yMode val="edge"/>
          <c:x val="0.40600944444444398"/>
          <c:y val="0.104563492063492"/>
        </c:manualLayout>
      </c:layout>
      <c:overlay val="0"/>
      <c:spPr>
        <a:noFill/>
        <a:ln>
          <a:noFill/>
        </a:ln>
        <a:effectLst/>
      </c:spPr>
    </c:title>
    <c:autoTitleDeleted val="0"/>
    <c:view3D>
      <c:rotX val="30"/>
      <c:rotY val="0"/>
      <c:depthPercent val="100"/>
      <c:rAngAx val="0"/>
    </c:view3D>
    <c:floor>
      <c:thickness val="0"/>
      <c:spPr>
        <a:noFill/>
        <a:ln>
          <a:noFill/>
        </a:ln>
        <a:effectLst/>
      </c:spPr>
    </c:floor>
    <c:sideWall>
      <c:thickness val="0"/>
      <c:spPr>
        <a:noFill/>
        <a:ln>
          <a:noFill/>
        </a:ln>
        <a:effectLst/>
      </c:spPr>
    </c:sideWall>
    <c:backWall>
      <c:thickness val="0"/>
      <c:spPr>
        <a:noFill/>
        <a:ln>
          <a:noFill/>
        </a:ln>
        <a:effectLst/>
      </c:spPr>
    </c:backWall>
    <c:plotArea>
      <c:layout/>
      <c:pie3D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1-BB4F-4CFA-917F-34CE1BDEDA53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3-BB4F-4CFA-917F-34CE1BDEDA53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5-BB4F-4CFA-917F-34CE1BDEDA53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7-BB4F-4CFA-917F-34CE1BDEDA53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9-BB4F-4CFA-917F-34CE1BDEDA53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B-BB4F-4CFA-917F-34CE1BDEDA53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D-BB4F-4CFA-917F-34CE1BDEDA53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F-BB4F-4CFA-917F-34CE1BDEDA53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1-BB4F-4CFA-917F-34CE1BDEDA53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3-BB4F-4CFA-917F-34CE1BDEDA53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5-BB4F-4CFA-917F-34CE1BDEDA53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7-BB4F-4CFA-917F-34CE1BDEDA53}"/>
              </c:ext>
            </c:extLst>
          </c:dPt>
          <c:dPt>
            <c:idx val="12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9-BB4F-4CFA-917F-34CE1BDEDA53}"/>
              </c:ext>
            </c:extLst>
          </c:dPt>
          <c:dLbls>
            <c:dLbl>
              <c:idx val="0"/>
              <c:layout>
                <c:manualLayout>
                  <c:x val="5.47644444444444E-2"/>
                  <c:y val="2.7666975881261598E-2"/>
                </c:manualLayout>
              </c:layout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separator>
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BB4F-4CFA-917F-34CE1BDEDA53}"/>
                </c:ext>
              </c:extLst>
            </c:dLbl>
            <c:dLbl>
              <c:idx val="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BB4F-4CFA-917F-34CE1BDEDA53}"/>
                </c:ext>
              </c:extLst>
            </c:dLbl>
            <c:dLbl>
              <c:idx val="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BB4F-4CFA-917F-34CE1BDEDA53}"/>
                </c:ext>
              </c:extLst>
            </c:dLbl>
            <c:dLbl>
              <c:idx val="3"/>
              <c:layout>
                <c:manualLayout>
                  <c:x val="-0.24389621609798801"/>
                  <c:y val="-0.15519393409157201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zh-CN" sz="900" b="0" i="0" u="none" strike="noStrike" kern="1200" baseline="0">
                      <a:solidFill>
                        <a:schemeClr val="bg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separator>
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BB4F-4CFA-917F-34CE1BDEDA53}"/>
                </c:ext>
              </c:extLst>
            </c:dLbl>
            <c:dLbl>
              <c:idx val="4"/>
              <c:layout>
                <c:manualLayout>
                  <c:x val="-0.120168472222222"/>
                  <c:y val="-0.103369408369408"/>
                </c:manualLayout>
              </c:layout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separator>
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BB4F-4CFA-917F-34CE1BDEDA53}"/>
                </c:ext>
              </c:extLst>
            </c:dLbl>
            <c:dLbl>
              <c:idx val="5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zh-CN" sz="900" b="0" i="0" u="none" strike="noStrike" kern="1200" baseline="0">
                      <a:solidFill>
                        <a:schemeClr val="bg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separator>
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BB4F-4CFA-917F-34CE1BDEDA53}"/>
                </c:ext>
              </c:extLst>
            </c:dLbl>
            <c:dLbl>
              <c:idx val="6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BB4F-4CFA-917F-34CE1BDEDA53}"/>
                </c:ext>
              </c:extLst>
            </c:dLbl>
            <c:dLbl>
              <c:idx val="7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F-BB4F-4CFA-917F-34CE1BDEDA53}"/>
                </c:ext>
              </c:extLst>
            </c:dLbl>
            <c:dLbl>
              <c:idx val="8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1-BB4F-4CFA-917F-34CE1BDEDA53}"/>
                </c:ext>
              </c:extLst>
            </c:dLbl>
            <c:dLbl>
              <c:idx val="9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3-BB4F-4CFA-917F-34CE1BDEDA53}"/>
                </c:ext>
              </c:extLst>
            </c:dLbl>
            <c:dLbl>
              <c:idx val="1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5-BB4F-4CFA-917F-34CE1BDEDA53}"/>
                </c:ext>
              </c:extLst>
            </c:dLbl>
            <c:dLbl>
              <c:idx val="11"/>
              <c:layout>
                <c:manualLayout>
                  <c:x val="0.12910430555555599"/>
                  <c:y val="0.110122655122655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zh-CN" sz="900" b="0" i="0" u="none" strike="noStrike" kern="1200" baseline="0">
                      <a:solidFill>
                        <a:schemeClr val="bg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separator>
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7-BB4F-4CFA-917F-34CE1BDEDA53}"/>
                </c:ext>
              </c:extLst>
            </c:dLbl>
            <c:dLbl>
              <c:idx val="1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9-BB4F-4CFA-917F-34CE1BDEDA5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zh-CN"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bestFit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prstDash val="solid"/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individuals-less'!$F$1:$R$1</c:f>
              <c:strCache>
                <c:ptCount val="13"/>
                <c:pt idx="0">
                  <c:v>TβMCA</c:v>
                </c:pt>
                <c:pt idx="1">
                  <c:v>TCA</c:v>
                </c:pt>
                <c:pt idx="2">
                  <c:v>GCA</c:v>
                </c:pt>
                <c:pt idx="3">
                  <c:v>βMCA</c:v>
                </c:pt>
                <c:pt idx="4">
                  <c:v>CA</c:v>
                </c:pt>
                <c:pt idx="5">
                  <c:v>CDCA</c:v>
                </c:pt>
                <c:pt idx="6">
                  <c:v>TωMCA</c:v>
                </c:pt>
                <c:pt idx="7">
                  <c:v>TLCA</c:v>
                </c:pt>
                <c:pt idx="8">
                  <c:v>GLCA</c:v>
                </c:pt>
                <c:pt idx="9">
                  <c:v>isoDCA</c:v>
                </c:pt>
                <c:pt idx="10">
                  <c:v>12keto_LCA</c:v>
                </c:pt>
                <c:pt idx="11">
                  <c:v>DCA</c:v>
                </c:pt>
                <c:pt idx="12">
                  <c:v>LCA</c:v>
                </c:pt>
              </c:strCache>
            </c:strRef>
          </c:cat>
          <c:val>
            <c:numRef>
              <c:f>'individuals-less'!$F$27:$R$27</c:f>
              <c:numCache>
                <c:formatCode>0.00</c:formatCode>
                <c:ptCount val="13"/>
                <c:pt idx="0">
                  <c:v>0.12019496138288301</c:v>
                </c:pt>
                <c:pt idx="1">
                  <c:v>5.53562333491723E-2</c:v>
                </c:pt>
                <c:pt idx="2">
                  <c:v>5.8123453644282801E-4</c:v>
                </c:pt>
                <c:pt idx="3">
                  <c:v>0.3773095177095</c:v>
                </c:pt>
                <c:pt idx="4">
                  <c:v>6.0148320610145002E-2</c:v>
                </c:pt>
                <c:pt idx="5">
                  <c:v>0.145706629425113</c:v>
                </c:pt>
                <c:pt idx="6">
                  <c:v>2.7888214775816302E-2</c:v>
                </c:pt>
                <c:pt idx="7">
                  <c:v>6.9007923202697198E-4</c:v>
                </c:pt>
                <c:pt idx="8">
                  <c:v>1.33111076562987E-3</c:v>
                </c:pt>
                <c:pt idx="9">
                  <c:v>6.8941745820883197E-3</c:v>
                </c:pt>
                <c:pt idx="10">
                  <c:v>6.6940131454831702E-3</c:v>
                </c:pt>
                <c:pt idx="11">
                  <c:v>0.207485402104332</c:v>
                </c:pt>
                <c:pt idx="12">
                  <c:v>1.0431210526811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A-BB4F-4CFA-917F-34CE1BDEDA5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</c:pie3D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/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view3D>
      <c:rotX val="30"/>
      <c:rotY val="0"/>
      <c:depthPercent val="100"/>
      <c:rAngAx val="0"/>
    </c:view3D>
    <c:floor>
      <c:thickness val="0"/>
      <c:spPr>
        <a:noFill/>
        <a:ln>
          <a:noFill/>
        </a:ln>
        <a:effectLst/>
      </c:spPr>
    </c:floor>
    <c:sideWall>
      <c:thickness val="0"/>
      <c:spPr>
        <a:noFill/>
        <a:ln>
          <a:noFill/>
        </a:ln>
        <a:effectLst/>
      </c:spPr>
    </c:sideWall>
    <c:backWall>
      <c:thickness val="0"/>
      <c:spPr>
        <a:noFill/>
        <a:ln>
          <a:noFill/>
        </a:ln>
        <a:effectLst/>
      </c:spPr>
    </c:backWall>
    <c:plotArea>
      <c:layout>
        <c:manualLayout>
          <c:layoutTarget val="inner"/>
          <c:xMode val="edge"/>
          <c:yMode val="edge"/>
          <c:x val="3.05555555555556E-2"/>
          <c:y val="0.67592592592592604"/>
          <c:w val="2.5000000000000001E-2"/>
          <c:h val="1.79381743948673E-2"/>
        </c:manualLayout>
      </c:layout>
      <c:pie3D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1-1B8D-475A-992F-3C752866C898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3-1B8D-475A-992F-3C752866C898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5-1B8D-475A-992F-3C752866C898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7-1B8D-475A-992F-3C752866C898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9-1B8D-475A-992F-3C752866C898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B-1B8D-475A-992F-3C752866C898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D-1B8D-475A-992F-3C752866C898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F-1B8D-475A-992F-3C752866C898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1-1B8D-475A-992F-3C752866C898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3-1B8D-475A-992F-3C752866C898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5-1B8D-475A-992F-3C752866C898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7-1B8D-475A-992F-3C752866C898}"/>
              </c:ext>
            </c:extLst>
          </c:dPt>
          <c:dPt>
            <c:idx val="12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25400">
                <a:solidFill>
                  <a:schemeClr val="lt1"/>
                </a:solidFill>
              </a:ln>
              <a:effectLst/>
              <a:scene3d>
                <a:camera prst="orthographicFront"/>
                <a:lightRig rig="threePt" dir="t"/>
              </a:scene3d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19-1B8D-475A-992F-3C752866C898}"/>
              </c:ext>
            </c:extLst>
          </c:dPt>
          <c:cat>
            <c:strRef>
              <c:f>'individuals-less'!$F$1:$R$1</c:f>
              <c:strCache>
                <c:ptCount val="13"/>
                <c:pt idx="0">
                  <c:v>TβMCA</c:v>
                </c:pt>
                <c:pt idx="1">
                  <c:v>TCA</c:v>
                </c:pt>
                <c:pt idx="2">
                  <c:v>GCA</c:v>
                </c:pt>
                <c:pt idx="3">
                  <c:v>βMCA</c:v>
                </c:pt>
                <c:pt idx="4">
                  <c:v>CA</c:v>
                </c:pt>
                <c:pt idx="5">
                  <c:v>CDCA</c:v>
                </c:pt>
                <c:pt idx="6">
                  <c:v>TωMCA</c:v>
                </c:pt>
                <c:pt idx="7">
                  <c:v>TLCA</c:v>
                </c:pt>
                <c:pt idx="8">
                  <c:v>GLCA</c:v>
                </c:pt>
                <c:pt idx="9">
                  <c:v>isoDCA</c:v>
                </c:pt>
                <c:pt idx="10">
                  <c:v>12keto_LCA</c:v>
                </c:pt>
                <c:pt idx="11">
                  <c:v>DCA</c:v>
                </c:pt>
                <c:pt idx="12">
                  <c:v>LCA</c:v>
                </c:pt>
              </c:strCache>
            </c:strRef>
          </c:cat>
          <c:val>
            <c:numRef>
              <c:f>'individuals-less'!$F$29:$R$29</c:f>
              <c:numCache>
                <c:formatCode>0.00</c:formatCode>
                <c:ptCount val="13"/>
                <c:pt idx="0">
                  <c:v>5.9538309289589697E-2</c:v>
                </c:pt>
                <c:pt idx="1">
                  <c:v>4.9489023322976299E-2</c:v>
                </c:pt>
                <c:pt idx="2">
                  <c:v>7.1936452497396795E-4</c:v>
                </c:pt>
                <c:pt idx="3">
                  <c:v>0.39076109691489203</c:v>
                </c:pt>
                <c:pt idx="4">
                  <c:v>6.3782039470691498E-2</c:v>
                </c:pt>
                <c:pt idx="5">
                  <c:v>0.14906001549532599</c:v>
                </c:pt>
                <c:pt idx="6">
                  <c:v>2.33963469007092E-2</c:v>
                </c:pt>
                <c:pt idx="7">
                  <c:v>7.1183365164655197E-4</c:v>
                </c:pt>
                <c:pt idx="8">
                  <c:v>8.1106398254897295E-4</c:v>
                </c:pt>
                <c:pt idx="9">
                  <c:v>7.4119852021661504E-3</c:v>
                </c:pt>
                <c:pt idx="10">
                  <c:v>1.1567975171596599E-2</c:v>
                </c:pt>
                <c:pt idx="11">
                  <c:v>0.23837113411823699</c:v>
                </c:pt>
                <c:pt idx="12">
                  <c:v>5.2636651503493196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A-1B8D-475A-992F-3C752866C8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</c:pie3DChart>
      <c:spPr>
        <a:noFill/>
        <a:ln w="25400">
          <a:noFill/>
        </a:ln>
        <a:effectLst/>
      </c:spPr>
    </c:plotArea>
    <c:legend>
      <c:legendPos val="b"/>
      <c:layout>
        <c:manualLayout>
          <c:xMode val="edge"/>
          <c:yMode val="edge"/>
          <c:x val="2.17279982143555E-2"/>
          <c:y val="0.15931960428023401"/>
          <c:w val="0.95249413064145605"/>
          <c:h val="0.5141459721380979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zh-CN"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view3D>
      <c:rotX val="30"/>
      <c:rotY val="0"/>
      <c:depthPercent val="100"/>
      <c:rAngAx val="0"/>
    </c:view3D>
    <c:floor>
      <c:thickness val="0"/>
    </c:floor>
    <c:sideWall>
      <c:thickness val="0"/>
    </c:sideWall>
    <c:backWall>
      <c:thickness val="0"/>
    </c:backWall>
    <c:plotArea>
      <c:layout/>
      <c:pie3DChart>
        <c:varyColors val="1"/>
        <c:dLbls>
          <c:showLegendKey val="0"/>
          <c:showVal val="0"/>
          <c:showCatName val="0"/>
          <c:showSerName val="0"/>
          <c:showPercent val="0"/>
          <c:showBubbleSize val="0"/>
          <c:showLeaderLines val="0"/>
        </c:dLbls>
      </c:pie3DChart>
    </c:plotArea>
    <c:plotVisOnly val="1"/>
    <c:dispBlanksAs val="gap"/>
    <c:showDLblsOverMax val="0"/>
  </c:chart>
  <c:txPr>
    <a:bodyPr/>
    <a:lstStyle/>
    <a:p>
      <a:pPr>
        <a:defRPr lang="zh-CN"/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view3D>
      <c:rotX val="30"/>
      <c:rotY val="0"/>
      <c:depthPercent val="100"/>
      <c:rAngAx val="0"/>
    </c:view3D>
    <c:floor>
      <c:thickness val="0"/>
    </c:floor>
    <c:sideWall>
      <c:thickness val="0"/>
    </c:sideWall>
    <c:backWall>
      <c:thickness val="0"/>
    </c:backWall>
    <c:plotArea>
      <c:layout/>
      <c:pie3DChart>
        <c:varyColors val="1"/>
        <c:dLbls>
          <c:showLegendKey val="0"/>
          <c:showVal val="0"/>
          <c:showCatName val="0"/>
          <c:showSerName val="0"/>
          <c:showPercent val="0"/>
          <c:showBubbleSize val="0"/>
          <c:showLeaderLines val="0"/>
        </c:dLbls>
      </c:pie3DChart>
    </c:plotArea>
    <c:plotVisOnly val="1"/>
    <c:dispBlanksAs val="gap"/>
    <c:showDLblsOverMax val="0"/>
  </c:chart>
  <c:txPr>
    <a:bodyPr/>
    <a:lstStyle/>
    <a:p>
      <a:pPr>
        <a:defRPr lang="zh-CN"/>
      </a:pPr>
      <a:endParaRPr lang="en-U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view3D>
      <c:rotX val="30"/>
      <c:rotY val="0"/>
      <c:depthPercent val="100"/>
      <c:rAngAx val="0"/>
    </c:view3D>
    <c:floor>
      <c:thickness val="0"/>
    </c:floor>
    <c:sideWall>
      <c:thickness val="0"/>
    </c:sideWall>
    <c:backWall>
      <c:thickness val="0"/>
    </c:backWall>
    <c:plotArea>
      <c:layout/>
      <c:pie3DChart>
        <c:varyColors val="1"/>
        <c:dLbls>
          <c:showLegendKey val="0"/>
          <c:showVal val="0"/>
          <c:showCatName val="0"/>
          <c:showSerName val="0"/>
          <c:showPercent val="0"/>
          <c:showBubbleSize val="0"/>
          <c:showLeaderLines val="0"/>
        </c:dLbls>
      </c:pie3DChart>
    </c:plotArea>
    <c:plotVisOnly val="1"/>
    <c:dispBlanksAs val="gap"/>
    <c:showDLblsOverMax val="0"/>
  </c:chart>
  <c:txPr>
    <a:bodyPr/>
    <a:lstStyle/>
    <a:p>
      <a:pPr>
        <a:defRPr lang="zh-CN"/>
      </a:pPr>
      <a:endParaRPr lang="en-US"/>
    </a:p>
  </c:txPr>
  <c:externalData r:id="rId1">
    <c:autoUpdate val="0"/>
  </c:externalData>
</c:chartSpace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10.vml.rels><?xml version="1.0" encoding="UTF-8" standalone="yes"?>
<Relationships xmlns="http://schemas.openxmlformats.org/package/2006/relationships"><Relationship Id="rId2" Type="http://schemas.openxmlformats.org/officeDocument/2006/relationships/image" Target="../media/image56.emf"/><Relationship Id="rId1" Type="http://schemas.openxmlformats.org/officeDocument/2006/relationships/image" Target="../media/image55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8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image" Target="../media/image11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13.emf"/></Relationships>
</file>

<file path=ppt/drawings/_rels/vmlDrawing5.vml.rels><?xml version="1.0" encoding="UTF-8" standalone="yes"?>
<Relationships xmlns="http://schemas.openxmlformats.org/package/2006/relationships"><Relationship Id="rId8" Type="http://schemas.openxmlformats.org/officeDocument/2006/relationships/image" Target="../media/image25.emf"/><Relationship Id="rId3" Type="http://schemas.openxmlformats.org/officeDocument/2006/relationships/image" Target="../media/image20.emf"/><Relationship Id="rId7" Type="http://schemas.openxmlformats.org/officeDocument/2006/relationships/image" Target="../media/image24.emf"/><Relationship Id="rId2" Type="http://schemas.openxmlformats.org/officeDocument/2006/relationships/image" Target="../media/image19.emf"/><Relationship Id="rId1" Type="http://schemas.openxmlformats.org/officeDocument/2006/relationships/image" Target="../media/image18.emf"/><Relationship Id="rId6" Type="http://schemas.openxmlformats.org/officeDocument/2006/relationships/image" Target="../media/image23.emf"/><Relationship Id="rId5" Type="http://schemas.openxmlformats.org/officeDocument/2006/relationships/image" Target="../media/image22.emf"/><Relationship Id="rId10" Type="http://schemas.openxmlformats.org/officeDocument/2006/relationships/image" Target="../media/image27.emf"/><Relationship Id="rId4" Type="http://schemas.openxmlformats.org/officeDocument/2006/relationships/image" Target="../media/image21.emf"/><Relationship Id="rId9" Type="http://schemas.openxmlformats.org/officeDocument/2006/relationships/image" Target="../media/image26.e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28.emf"/></Relationships>
</file>

<file path=ppt/drawings/_rels/vmlDrawing7.vml.rels><?xml version="1.0" encoding="UTF-8" standalone="yes"?>
<Relationships xmlns="http://schemas.openxmlformats.org/package/2006/relationships"><Relationship Id="rId1" Type="http://schemas.openxmlformats.org/officeDocument/2006/relationships/image" Target="../media/image37.emf"/></Relationships>
</file>

<file path=ppt/drawings/_rels/vmlDrawing8.vml.rels><?xml version="1.0" encoding="UTF-8" standalone="yes"?>
<Relationships xmlns="http://schemas.openxmlformats.org/package/2006/relationships"><Relationship Id="rId8" Type="http://schemas.openxmlformats.org/officeDocument/2006/relationships/image" Target="../media/image45.emf"/><Relationship Id="rId3" Type="http://schemas.openxmlformats.org/officeDocument/2006/relationships/image" Target="../media/image40.emf"/><Relationship Id="rId7" Type="http://schemas.openxmlformats.org/officeDocument/2006/relationships/image" Target="../media/image44.emf"/><Relationship Id="rId2" Type="http://schemas.openxmlformats.org/officeDocument/2006/relationships/image" Target="../media/image39.emf"/><Relationship Id="rId1" Type="http://schemas.openxmlformats.org/officeDocument/2006/relationships/image" Target="../media/image38.emf"/><Relationship Id="rId6" Type="http://schemas.openxmlformats.org/officeDocument/2006/relationships/image" Target="../media/image43.emf"/><Relationship Id="rId5" Type="http://schemas.openxmlformats.org/officeDocument/2006/relationships/image" Target="../media/image42.emf"/><Relationship Id="rId4" Type="http://schemas.openxmlformats.org/officeDocument/2006/relationships/image" Target="../media/image41.emf"/></Relationships>
</file>

<file path=ppt/drawings/_rels/vmlDrawing9.vml.rels><?xml version="1.0" encoding="UTF-8" standalone="yes"?>
<Relationships xmlns="http://schemas.openxmlformats.org/package/2006/relationships"><Relationship Id="rId8" Type="http://schemas.openxmlformats.org/officeDocument/2006/relationships/image" Target="../media/image53.emf"/><Relationship Id="rId3" Type="http://schemas.openxmlformats.org/officeDocument/2006/relationships/image" Target="../media/image48.emf"/><Relationship Id="rId7" Type="http://schemas.openxmlformats.org/officeDocument/2006/relationships/image" Target="../media/image52.emf"/><Relationship Id="rId2" Type="http://schemas.openxmlformats.org/officeDocument/2006/relationships/image" Target="../media/image47.emf"/><Relationship Id="rId1" Type="http://schemas.openxmlformats.org/officeDocument/2006/relationships/image" Target="../media/image46.emf"/><Relationship Id="rId6" Type="http://schemas.openxmlformats.org/officeDocument/2006/relationships/image" Target="../media/image51.emf"/><Relationship Id="rId5" Type="http://schemas.openxmlformats.org/officeDocument/2006/relationships/image" Target="../media/image50.emf"/><Relationship Id="rId4" Type="http://schemas.openxmlformats.org/officeDocument/2006/relationships/image" Target="../media/image49.emf"/><Relationship Id="rId9" Type="http://schemas.openxmlformats.org/officeDocument/2006/relationships/image" Target="../media/image5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9AE538-F387-4594-918A-ED268D65173E}" type="datetimeFigureOut">
              <a:rPr lang="en-US" smtClean="0"/>
              <a:t>12/31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3788" y="1162050"/>
            <a:ext cx="228282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E27B5EA-CD5D-4069-A7A8-8FEDAD3CF220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E27B5EA-CD5D-4069-A7A8-8FEDAD3CF220}" type="slidenum">
              <a:rPr lang="en-US" smtClean="0"/>
              <a:t>4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646133"/>
            <a:ext cx="6217920" cy="3501813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282989"/>
            <a:ext cx="5486400" cy="2428451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A4E62-9FA0-4A7A-A9F3-8E0FE1D265E3}" type="datetimeFigureOut">
              <a:rPr lang="en-US" smtClean="0"/>
              <a:t>12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02192-CA08-4F75-8022-AA9403BD533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A4E62-9FA0-4A7A-A9F3-8E0FE1D265E3}" type="datetimeFigureOut">
              <a:rPr lang="en-US" smtClean="0"/>
              <a:t>12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02192-CA08-4F75-8022-AA9403BD533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535517"/>
            <a:ext cx="1577340" cy="852402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535517"/>
            <a:ext cx="4640580" cy="852402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A4E62-9FA0-4A7A-A9F3-8E0FE1D265E3}" type="datetimeFigureOut">
              <a:rPr lang="en-US" smtClean="0"/>
              <a:t>12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02192-CA08-4F75-8022-AA9403BD533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A4E62-9FA0-4A7A-A9F3-8E0FE1D265E3}" type="datetimeFigureOut">
              <a:rPr lang="en-US" smtClean="0"/>
              <a:t>12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02192-CA08-4F75-8022-AA9403BD533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507618"/>
            <a:ext cx="6309360" cy="4184014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731215"/>
            <a:ext cx="6309360" cy="2200274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A4E62-9FA0-4A7A-A9F3-8E0FE1D265E3}" type="datetimeFigureOut">
              <a:rPr lang="en-US" smtClean="0"/>
              <a:t>12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02192-CA08-4F75-8022-AA9403BD533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677584"/>
            <a:ext cx="3108960" cy="638196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677584"/>
            <a:ext cx="3108960" cy="638196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A4E62-9FA0-4A7A-A9F3-8E0FE1D265E3}" type="datetimeFigureOut">
              <a:rPr lang="en-US" smtClean="0"/>
              <a:t>12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02192-CA08-4F75-8022-AA9403BD533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535519"/>
            <a:ext cx="6309360" cy="194415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465706"/>
            <a:ext cx="3094672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674110"/>
            <a:ext cx="3094672" cy="540406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465706"/>
            <a:ext cx="3109913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674110"/>
            <a:ext cx="3109913" cy="540406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A4E62-9FA0-4A7A-A9F3-8E0FE1D265E3}" type="datetimeFigureOut">
              <a:rPr lang="en-US" smtClean="0"/>
              <a:t>12/3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02192-CA08-4F75-8022-AA9403BD533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A4E62-9FA0-4A7A-A9F3-8E0FE1D265E3}" type="datetimeFigureOut">
              <a:rPr lang="en-US" smtClean="0"/>
              <a:t>12/3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02192-CA08-4F75-8022-AA9403BD533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A4E62-9FA0-4A7A-A9F3-8E0FE1D265E3}" type="datetimeFigureOut">
              <a:rPr lang="en-US" smtClean="0"/>
              <a:t>12/3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02192-CA08-4F75-8022-AA9403BD533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448226"/>
            <a:ext cx="3703320" cy="7147983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A4E62-9FA0-4A7A-A9F3-8E0FE1D265E3}" type="datetimeFigureOut">
              <a:rPr lang="en-US" smtClean="0"/>
              <a:t>12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02192-CA08-4F75-8022-AA9403BD533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448226"/>
            <a:ext cx="3703320" cy="7147983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A4E62-9FA0-4A7A-A9F3-8E0FE1D265E3}" type="datetimeFigureOut">
              <a:rPr lang="en-US" smtClean="0"/>
              <a:t>12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902192-CA08-4F75-8022-AA9403BD533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35519"/>
            <a:ext cx="630936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677584"/>
            <a:ext cx="630936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8A4E62-9FA0-4A7A-A9F3-8E0FE1D265E3}" type="datetimeFigureOut">
              <a:rPr lang="en-US" smtClean="0"/>
              <a:t>12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9322649"/>
            <a:ext cx="246888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902192-CA08-4F75-8022-AA9403BD5335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tiff"/><Relationship Id="rId3" Type="http://schemas.openxmlformats.org/officeDocument/2006/relationships/oleObject" Target="../embeddings/oleObject1.bin"/><Relationship Id="rId7" Type="http://schemas.openxmlformats.org/officeDocument/2006/relationships/image" Target="../media/image4.tiff"/><Relationship Id="rId12" Type="http://schemas.openxmlformats.org/officeDocument/2006/relationships/image" Target="../media/image3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3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7.tiff"/><Relationship Id="rId4" Type="http://schemas.openxmlformats.org/officeDocument/2006/relationships/image" Target="../media/image1.emf"/><Relationship Id="rId9" Type="http://schemas.openxmlformats.org/officeDocument/2006/relationships/image" Target="../media/image6.tif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9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7.vml"/><Relationship Id="rId4" Type="http://schemas.openxmlformats.org/officeDocument/2006/relationships/image" Target="../media/image37.emf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emf"/><Relationship Id="rId13" Type="http://schemas.openxmlformats.org/officeDocument/2006/relationships/oleObject" Target="../embeddings/oleObject25.bin"/><Relationship Id="rId18" Type="http://schemas.openxmlformats.org/officeDocument/2006/relationships/image" Target="../media/image45.emf"/><Relationship Id="rId3" Type="http://schemas.openxmlformats.org/officeDocument/2006/relationships/oleObject" Target="../embeddings/oleObject20.bin"/><Relationship Id="rId21" Type="http://schemas.openxmlformats.org/officeDocument/2006/relationships/chart" Target="../charts/chart3.xml"/><Relationship Id="rId7" Type="http://schemas.openxmlformats.org/officeDocument/2006/relationships/oleObject" Target="../embeddings/oleObject22.bin"/><Relationship Id="rId12" Type="http://schemas.openxmlformats.org/officeDocument/2006/relationships/image" Target="../media/image42.emf"/><Relationship Id="rId17" Type="http://schemas.openxmlformats.org/officeDocument/2006/relationships/oleObject" Target="../embeddings/oleObject27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44.emf"/><Relationship Id="rId20" Type="http://schemas.openxmlformats.org/officeDocument/2006/relationships/chart" Target="../charts/chart2.xml"/><Relationship Id="rId1" Type="http://schemas.openxmlformats.org/officeDocument/2006/relationships/vmlDrawing" Target="../drawings/vmlDrawing8.vml"/><Relationship Id="rId6" Type="http://schemas.openxmlformats.org/officeDocument/2006/relationships/image" Target="../media/image39.emf"/><Relationship Id="rId11" Type="http://schemas.openxmlformats.org/officeDocument/2006/relationships/oleObject" Target="../embeddings/oleObject24.bin"/><Relationship Id="rId24" Type="http://schemas.openxmlformats.org/officeDocument/2006/relationships/chart" Target="../charts/chart6.xml"/><Relationship Id="rId5" Type="http://schemas.openxmlformats.org/officeDocument/2006/relationships/oleObject" Target="../embeddings/oleObject21.bin"/><Relationship Id="rId15" Type="http://schemas.openxmlformats.org/officeDocument/2006/relationships/oleObject" Target="../embeddings/oleObject26.bin"/><Relationship Id="rId23" Type="http://schemas.openxmlformats.org/officeDocument/2006/relationships/chart" Target="../charts/chart5.xml"/><Relationship Id="rId10" Type="http://schemas.openxmlformats.org/officeDocument/2006/relationships/image" Target="../media/image41.emf"/><Relationship Id="rId19" Type="http://schemas.openxmlformats.org/officeDocument/2006/relationships/chart" Target="../charts/chart1.xml"/><Relationship Id="rId4" Type="http://schemas.openxmlformats.org/officeDocument/2006/relationships/image" Target="../media/image38.emf"/><Relationship Id="rId9" Type="http://schemas.openxmlformats.org/officeDocument/2006/relationships/oleObject" Target="../embeddings/oleObject23.bin"/><Relationship Id="rId14" Type="http://schemas.openxmlformats.org/officeDocument/2006/relationships/image" Target="../media/image43.emf"/><Relationship Id="rId22" Type="http://schemas.openxmlformats.org/officeDocument/2006/relationships/chart" Target="../charts/chart4.xml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8.emf"/><Relationship Id="rId13" Type="http://schemas.openxmlformats.org/officeDocument/2006/relationships/oleObject" Target="../embeddings/oleObject33.bin"/><Relationship Id="rId18" Type="http://schemas.openxmlformats.org/officeDocument/2006/relationships/image" Target="../media/image53.emf"/><Relationship Id="rId3" Type="http://schemas.openxmlformats.org/officeDocument/2006/relationships/oleObject" Target="../embeddings/oleObject28.bin"/><Relationship Id="rId7" Type="http://schemas.openxmlformats.org/officeDocument/2006/relationships/oleObject" Target="../embeddings/oleObject30.bin"/><Relationship Id="rId12" Type="http://schemas.openxmlformats.org/officeDocument/2006/relationships/image" Target="../media/image50.emf"/><Relationship Id="rId17" Type="http://schemas.openxmlformats.org/officeDocument/2006/relationships/oleObject" Target="../embeddings/oleObject35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52.emf"/><Relationship Id="rId20" Type="http://schemas.openxmlformats.org/officeDocument/2006/relationships/image" Target="../media/image54.emf"/><Relationship Id="rId1" Type="http://schemas.openxmlformats.org/officeDocument/2006/relationships/vmlDrawing" Target="../drawings/vmlDrawing9.vml"/><Relationship Id="rId6" Type="http://schemas.openxmlformats.org/officeDocument/2006/relationships/image" Target="../media/image47.emf"/><Relationship Id="rId11" Type="http://schemas.openxmlformats.org/officeDocument/2006/relationships/oleObject" Target="../embeddings/oleObject32.bin"/><Relationship Id="rId5" Type="http://schemas.openxmlformats.org/officeDocument/2006/relationships/oleObject" Target="../embeddings/oleObject29.bin"/><Relationship Id="rId15" Type="http://schemas.openxmlformats.org/officeDocument/2006/relationships/oleObject" Target="../embeddings/oleObject34.bin"/><Relationship Id="rId10" Type="http://schemas.openxmlformats.org/officeDocument/2006/relationships/image" Target="../media/image49.emf"/><Relationship Id="rId19" Type="http://schemas.openxmlformats.org/officeDocument/2006/relationships/oleObject" Target="../embeddings/oleObject36.bin"/><Relationship Id="rId4" Type="http://schemas.openxmlformats.org/officeDocument/2006/relationships/image" Target="../media/image46.emf"/><Relationship Id="rId9" Type="http://schemas.openxmlformats.org/officeDocument/2006/relationships/oleObject" Target="../embeddings/oleObject31.bin"/><Relationship Id="rId14" Type="http://schemas.openxmlformats.org/officeDocument/2006/relationships/image" Target="../media/image51.em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7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0.vml"/><Relationship Id="rId6" Type="http://schemas.openxmlformats.org/officeDocument/2006/relationships/image" Target="../media/image56.emf"/><Relationship Id="rId5" Type="http://schemas.openxmlformats.org/officeDocument/2006/relationships/oleObject" Target="../embeddings/oleObject38.bin"/><Relationship Id="rId4" Type="http://schemas.openxmlformats.org/officeDocument/2006/relationships/image" Target="../media/image55.emf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chart" Target="../charts/chart8.xml"/><Relationship Id="rId3" Type="http://schemas.openxmlformats.org/officeDocument/2006/relationships/tags" Target="../tags/tag4.xml"/><Relationship Id="rId7" Type="http://schemas.openxmlformats.org/officeDocument/2006/relationships/chart" Target="../charts/chart7.xml"/><Relationship Id="rId2" Type="http://schemas.openxmlformats.org/officeDocument/2006/relationships/tags" Target="../tags/tag3.xml"/><Relationship Id="rId1" Type="http://schemas.openxmlformats.org/officeDocument/2006/relationships/tags" Target="../tags/tag2.xml"/><Relationship Id="rId6" Type="http://schemas.openxmlformats.org/officeDocument/2006/relationships/image" Target="../media/image57.tiff"/><Relationship Id="rId5" Type="http://schemas.openxmlformats.org/officeDocument/2006/relationships/slideLayout" Target="../slideLayouts/slideLayout2.xml"/><Relationship Id="rId4" Type="http://schemas.openxmlformats.org/officeDocument/2006/relationships/tags" Target="../tags/tag5.xml"/><Relationship Id="rId9" Type="http://schemas.openxmlformats.org/officeDocument/2006/relationships/image" Target="../media/image58.tiff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7" Type="http://schemas.openxmlformats.org/officeDocument/2006/relationships/chart" Target="../charts/chart14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3.xml"/><Relationship Id="rId5" Type="http://schemas.openxmlformats.org/officeDocument/2006/relationships/chart" Target="../charts/chart12.xml"/><Relationship Id="rId4" Type="http://schemas.openxmlformats.org/officeDocument/2006/relationships/chart" Target="../charts/chart1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0.png"/><Relationship Id="rId5" Type="http://schemas.openxmlformats.org/officeDocument/2006/relationships/image" Target="../media/image8.emf"/><Relationship Id="rId4" Type="http://schemas.openxmlformats.org/officeDocument/2006/relationships/oleObject" Target="../embeddings/oleObject4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2.e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11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7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17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16.png"/><Relationship Id="rId5" Type="http://schemas.openxmlformats.org/officeDocument/2006/relationships/image" Target="../media/image15.tiff"/><Relationship Id="rId4" Type="http://schemas.openxmlformats.org/officeDocument/2006/relationships/image" Target="../media/image14.tiff"/><Relationship Id="rId9" Type="http://schemas.openxmlformats.org/officeDocument/2006/relationships/image" Target="../media/image13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emf"/><Relationship Id="rId13" Type="http://schemas.openxmlformats.org/officeDocument/2006/relationships/oleObject" Target="../embeddings/oleObject13.bin"/><Relationship Id="rId18" Type="http://schemas.openxmlformats.org/officeDocument/2006/relationships/image" Target="../media/image25.emf"/><Relationship Id="rId3" Type="http://schemas.openxmlformats.org/officeDocument/2006/relationships/oleObject" Target="../embeddings/oleObject8.bin"/><Relationship Id="rId21" Type="http://schemas.openxmlformats.org/officeDocument/2006/relationships/oleObject" Target="../embeddings/oleObject17.bin"/><Relationship Id="rId7" Type="http://schemas.openxmlformats.org/officeDocument/2006/relationships/oleObject" Target="../embeddings/oleObject10.bin"/><Relationship Id="rId12" Type="http://schemas.openxmlformats.org/officeDocument/2006/relationships/image" Target="../media/image22.emf"/><Relationship Id="rId17" Type="http://schemas.openxmlformats.org/officeDocument/2006/relationships/oleObject" Target="../embeddings/oleObject15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24.emf"/><Relationship Id="rId20" Type="http://schemas.openxmlformats.org/officeDocument/2006/relationships/image" Target="../media/image26.emf"/><Relationship Id="rId1" Type="http://schemas.openxmlformats.org/officeDocument/2006/relationships/vmlDrawing" Target="../drawings/vmlDrawing5.vml"/><Relationship Id="rId6" Type="http://schemas.openxmlformats.org/officeDocument/2006/relationships/image" Target="../media/image19.emf"/><Relationship Id="rId11" Type="http://schemas.openxmlformats.org/officeDocument/2006/relationships/oleObject" Target="../embeddings/oleObject12.bin"/><Relationship Id="rId5" Type="http://schemas.openxmlformats.org/officeDocument/2006/relationships/oleObject" Target="../embeddings/oleObject9.bin"/><Relationship Id="rId15" Type="http://schemas.openxmlformats.org/officeDocument/2006/relationships/oleObject" Target="../embeddings/oleObject14.bin"/><Relationship Id="rId10" Type="http://schemas.openxmlformats.org/officeDocument/2006/relationships/image" Target="../media/image21.emf"/><Relationship Id="rId19" Type="http://schemas.openxmlformats.org/officeDocument/2006/relationships/oleObject" Target="../embeddings/oleObject16.bin"/><Relationship Id="rId4" Type="http://schemas.openxmlformats.org/officeDocument/2006/relationships/image" Target="../media/image18.emf"/><Relationship Id="rId9" Type="http://schemas.openxmlformats.org/officeDocument/2006/relationships/oleObject" Target="../embeddings/oleObject11.bin"/><Relationship Id="rId14" Type="http://schemas.openxmlformats.org/officeDocument/2006/relationships/image" Target="../media/image23.emf"/><Relationship Id="rId22" Type="http://schemas.openxmlformats.org/officeDocument/2006/relationships/image" Target="../media/image27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8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Relationship Id="rId4" Type="http://schemas.openxmlformats.org/officeDocument/2006/relationships/image" Target="../media/image28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对象 1"/>
          <p:cNvGraphicFramePr>
            <a:graphicFrameLocks noChangeAspect="1"/>
          </p:cNvGraphicFramePr>
          <p:nvPr/>
        </p:nvGraphicFramePr>
        <p:xfrm>
          <a:off x="1073150" y="812799"/>
          <a:ext cx="3162300" cy="1938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50" name="Prism 9" r:id="rId3" imgW="4362450" imgH="2628900" progId="Prism9.Document">
                  <p:embed/>
                </p:oleObj>
              </mc:Choice>
              <mc:Fallback>
                <p:oleObj name="Prism 9" r:id="rId3" imgW="4362450" imgH="2628900" progId="Prism9.Document">
                  <p:embed/>
                  <p:pic>
                    <p:nvPicPr>
                      <p:cNvPr id="0" name="对象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73150" y="812799"/>
                        <a:ext cx="3162300" cy="1938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900259" y="4412516"/>
            <a:ext cx="1847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43767" y="93003"/>
            <a:ext cx="16438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 Black" panose="020B0A04020102020204" pitchFamily="34" charset="0"/>
              </a:rPr>
              <a:t>Figure S1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445782" y="809290"/>
            <a:ext cx="31813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 Black" panose="020B0A04020102020204" pitchFamily="34" charset="0"/>
              </a:rPr>
              <a:t>a</a:t>
            </a:r>
          </a:p>
        </p:txBody>
      </p:sp>
      <p:graphicFrame>
        <p:nvGraphicFramePr>
          <p:cNvPr id="7" name="Object 6"/>
          <p:cNvGraphicFramePr/>
          <p:nvPr/>
        </p:nvGraphicFramePr>
        <p:xfrm>
          <a:off x="4348163" y="871538"/>
          <a:ext cx="1660525" cy="1508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51" name="Prism 9" r:id="rId5" imgW="2714625" imgH="2357755" progId="Prism9.Document">
                  <p:embed/>
                </p:oleObj>
              </mc:Choice>
              <mc:Fallback>
                <p:oleObj name="Prism 9" r:id="rId5" imgW="2714625" imgH="2357755" progId="Prism9.Document">
                  <p:embed/>
                  <p:pic>
                    <p:nvPicPr>
                      <p:cNvPr id="0" name="Object 6"/>
                      <p:cNvPicPr preferRelativeResize="0"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348163" y="871538"/>
                        <a:ext cx="1660525" cy="1508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445782" y="2893254"/>
            <a:ext cx="31813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 Black" panose="020B0A04020102020204" pitchFamily="34" charset="0"/>
              </a:rPr>
              <a:t>c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445782" y="5662613"/>
            <a:ext cx="31813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 Black" panose="020B0A04020102020204" pitchFamily="34" charset="0"/>
              </a:rPr>
              <a:t>d</a:t>
            </a:r>
          </a:p>
        </p:txBody>
      </p:sp>
      <p:pic>
        <p:nvPicPr>
          <p:cNvPr id="5" name="Picture 1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8750" y="7568066"/>
            <a:ext cx="2505316" cy="11887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8750" y="6320010"/>
            <a:ext cx="2505316" cy="11887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2818" y="6320010"/>
            <a:ext cx="2505315" cy="11887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2817" y="7568066"/>
            <a:ext cx="2505315" cy="118872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4" name="Rectangle 23"/>
          <p:cNvSpPr/>
          <p:nvPr/>
        </p:nvSpPr>
        <p:spPr>
          <a:xfrm>
            <a:off x="1836058" y="6042218"/>
            <a:ext cx="395030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Control                                        BBR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900664" y="5662613"/>
            <a:ext cx="44294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 Black" panose="020B0A04020102020204" pitchFamily="34" charset="0"/>
              </a:rPr>
              <a:t>H&amp;E Staining of Mdr2</a:t>
            </a:r>
            <a:r>
              <a:rPr lang="en-US" sz="1600" baseline="30000" dirty="0">
                <a:latin typeface="Arial Black" panose="020B0A04020102020204" pitchFamily="34" charset="0"/>
              </a:rPr>
              <a:t>-/-</a:t>
            </a:r>
            <a:r>
              <a:rPr lang="en-US" sz="1600" dirty="0">
                <a:latin typeface="Arial Black" panose="020B0A04020102020204" pitchFamily="34" charset="0"/>
              </a:rPr>
              <a:t> (C57/BL6)</a:t>
            </a:r>
          </a:p>
        </p:txBody>
      </p:sp>
      <p:sp>
        <p:nvSpPr>
          <p:cNvPr id="26" name="Rectangle 25"/>
          <p:cNvSpPr/>
          <p:nvPr/>
        </p:nvSpPr>
        <p:spPr>
          <a:xfrm>
            <a:off x="509580" y="7925279"/>
            <a:ext cx="48590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200" b="1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40X</a:t>
            </a:r>
            <a:endParaRPr lang="en-US" sz="1400" b="1" kern="100" dirty="0">
              <a:effectLst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7" name="Rectangle 26"/>
          <p:cNvSpPr/>
          <p:nvPr/>
        </p:nvSpPr>
        <p:spPr>
          <a:xfrm>
            <a:off x="522643" y="6793966"/>
            <a:ext cx="48590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200" b="1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20X</a:t>
            </a:r>
            <a:endParaRPr lang="en-US" sz="1400" b="1" kern="100" dirty="0">
              <a:effectLst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graphicFrame>
        <p:nvGraphicFramePr>
          <p:cNvPr id="20" name="Object 19"/>
          <p:cNvGraphicFramePr>
            <a:graphicFrameLocks noChangeAspect="1"/>
          </p:cNvGraphicFramePr>
          <p:nvPr/>
        </p:nvGraphicFramePr>
        <p:xfrm>
          <a:off x="1050925" y="2557463"/>
          <a:ext cx="4438650" cy="3095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52" name="Prism 10" r:id="rId11" imgW="3638550" imgH="2538730" progId="Prism10.Document">
                  <p:embed/>
                </p:oleObj>
              </mc:Choice>
              <mc:Fallback>
                <p:oleObj name="Prism 10" r:id="rId11" imgW="3638550" imgH="2538730" progId="Prism10.Document">
                  <p:embed/>
                  <p:pic>
                    <p:nvPicPr>
                      <p:cNvPr id="0" name="Object 19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050925" y="2557463"/>
                        <a:ext cx="4438650" cy="3095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TextBox 16"/>
          <p:cNvSpPr txBox="1"/>
          <p:nvPr/>
        </p:nvSpPr>
        <p:spPr>
          <a:xfrm>
            <a:off x="4049292" y="809290"/>
            <a:ext cx="31813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 Black" panose="020B0A04020102020204" pitchFamily="34" charset="0"/>
              </a:rPr>
              <a:t>b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1886" y="1407360"/>
            <a:ext cx="5549289" cy="3917413"/>
          </a:xfrm>
          <a:prstGeom prst="rect">
            <a:avLst/>
          </a:prstGeom>
        </p:spPr>
      </p:pic>
      <p:pic>
        <p:nvPicPr>
          <p:cNvPr id="4" name="图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1886" y="5400261"/>
            <a:ext cx="5549289" cy="3917413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598415" y="843319"/>
            <a:ext cx="4548201" cy="350865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68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Protein processing in endoplasmic reticulum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17396" y="122358"/>
            <a:ext cx="15349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 Black" panose="020B0A04020102020204" pitchFamily="34" charset="0"/>
              </a:rPr>
              <a:t>Figure S10</a:t>
            </a:r>
          </a:p>
        </p:txBody>
      </p:sp>
      <p:sp>
        <p:nvSpPr>
          <p:cNvPr id="9" name="Rectangle 8"/>
          <p:cNvSpPr/>
          <p:nvPr/>
        </p:nvSpPr>
        <p:spPr>
          <a:xfrm>
            <a:off x="-48005" y="7180806"/>
            <a:ext cx="136447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/>
            <a:r>
              <a:rPr lang="en-US" sz="1200" b="1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BR vs. Control</a:t>
            </a:r>
          </a:p>
        </p:txBody>
      </p:sp>
      <p:sp>
        <p:nvSpPr>
          <p:cNvPr id="11" name="Rectangle 10"/>
          <p:cNvSpPr/>
          <p:nvPr/>
        </p:nvSpPr>
        <p:spPr>
          <a:xfrm>
            <a:off x="30930" y="2876369"/>
            <a:ext cx="123142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/>
            <a:r>
              <a:rPr lang="en-US" sz="1200" b="1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dr2</a:t>
            </a:r>
            <a:r>
              <a:rPr lang="en-US" sz="1200" b="1" kern="100" baseline="300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-/-</a:t>
            </a:r>
            <a:r>
              <a:rPr lang="en-US" sz="1200" b="1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vs. WT</a:t>
            </a: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17396" y="122358"/>
            <a:ext cx="15349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 Black" panose="020B0A04020102020204" pitchFamily="34" charset="0"/>
              </a:rPr>
              <a:t>Figure S11</a:t>
            </a:r>
          </a:p>
        </p:txBody>
      </p:sp>
      <p:graphicFrame>
        <p:nvGraphicFramePr>
          <p:cNvPr id="10" name="对象 1"/>
          <p:cNvGraphicFramePr>
            <a:graphicFrameLocks noChangeAspect="1"/>
          </p:cNvGraphicFramePr>
          <p:nvPr/>
        </p:nvGraphicFramePr>
        <p:xfrm>
          <a:off x="1955800" y="1125538"/>
          <a:ext cx="3505200" cy="6605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388" name="Prism 10" r:id="rId3" imgW="4160520" imgH="7833360" progId="Prism10.Document">
                  <p:embed/>
                </p:oleObj>
              </mc:Choice>
              <mc:Fallback>
                <p:oleObj name="Prism 10" r:id="rId3" imgW="4160520" imgH="7833360" progId="Prism10.Document">
                  <p:embed/>
                  <p:pic>
                    <p:nvPicPr>
                      <p:cNvPr id="0" name="对象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55800" y="1125538"/>
                        <a:ext cx="3505200" cy="6605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71800" y="625738"/>
            <a:ext cx="350266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Black" panose="020B0A04020102020204" pitchFamily="34" charset="0"/>
              </a:rPr>
              <a:t>a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ile acid profile in the intestine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71800" y="5033607"/>
            <a:ext cx="318706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Black" panose="020B0A04020102020204" pitchFamily="34" charset="0"/>
              </a:rPr>
              <a:t>c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ile acid profile in the feces</a:t>
            </a:r>
          </a:p>
        </p:txBody>
      </p:sp>
      <p:graphicFrame>
        <p:nvGraphicFramePr>
          <p:cNvPr id="16" name="对象 15"/>
          <p:cNvGraphicFramePr/>
          <p:nvPr/>
        </p:nvGraphicFramePr>
        <p:xfrm>
          <a:off x="560390" y="3525838"/>
          <a:ext cx="1336675" cy="1463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3" name="Prism 9" r:id="rId3" imgW="2990850" imgH="2984500" progId="Prism9.Document">
                  <p:embed/>
                </p:oleObj>
              </mc:Choice>
              <mc:Fallback>
                <p:oleObj name="Prism 9" r:id="rId3" imgW="2990850" imgH="2984500" progId="Prism9.Document">
                  <p:embed/>
                  <p:pic>
                    <p:nvPicPr>
                      <p:cNvPr id="0" name="对象 15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60390" y="3525838"/>
                        <a:ext cx="1336675" cy="14636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对象 23"/>
          <p:cNvGraphicFramePr/>
          <p:nvPr/>
        </p:nvGraphicFramePr>
        <p:xfrm>
          <a:off x="2101850" y="3525838"/>
          <a:ext cx="1338263" cy="1463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4" name="Prism 9" r:id="rId5" imgW="2997200" imgH="2984500" progId="Prism9.Document">
                  <p:embed/>
                </p:oleObj>
              </mc:Choice>
              <mc:Fallback>
                <p:oleObj name="Prism 9" r:id="rId5" imgW="2997200" imgH="2984500" progId="Prism9.Document">
                  <p:embed/>
                  <p:pic>
                    <p:nvPicPr>
                      <p:cNvPr id="0" name="对象 23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101850" y="3525838"/>
                        <a:ext cx="1338263" cy="14636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对象 24"/>
          <p:cNvGraphicFramePr/>
          <p:nvPr/>
        </p:nvGraphicFramePr>
        <p:xfrm>
          <a:off x="4900499" y="3526473"/>
          <a:ext cx="1371600" cy="14630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5" name="Prism 9" r:id="rId7" imgW="3117850" imgH="2984500" progId="Prism9.Document">
                  <p:embed/>
                </p:oleObj>
              </mc:Choice>
              <mc:Fallback>
                <p:oleObj name="Prism 9" r:id="rId7" imgW="3117850" imgH="2984500" progId="Prism9.Document">
                  <p:embed/>
                  <p:pic>
                    <p:nvPicPr>
                      <p:cNvPr id="0" name="对象 24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900499" y="3526473"/>
                        <a:ext cx="1371600" cy="146304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对象 25"/>
          <p:cNvGraphicFramePr/>
          <p:nvPr/>
        </p:nvGraphicFramePr>
        <p:xfrm>
          <a:off x="3402013" y="3526473"/>
          <a:ext cx="1371600" cy="14630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6" name="Prism 9" r:id="rId9" imgW="3175000" imgH="2984500" progId="Prism9.Document">
                  <p:embed/>
                </p:oleObj>
              </mc:Choice>
              <mc:Fallback>
                <p:oleObj name="Prism 9" r:id="rId9" imgW="3175000" imgH="2984500" progId="Prism9.Document">
                  <p:embed/>
                  <p:pic>
                    <p:nvPicPr>
                      <p:cNvPr id="0" name="对象 25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1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402013" y="3526473"/>
                        <a:ext cx="1371600" cy="146304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5"/>
          <p:cNvSpPr txBox="1"/>
          <p:nvPr/>
        </p:nvSpPr>
        <p:spPr>
          <a:xfrm>
            <a:off x="217396" y="122358"/>
            <a:ext cx="15349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 Black" panose="020B0A04020102020204" pitchFamily="34" charset="0"/>
              </a:rPr>
              <a:t>Figure S12</a:t>
            </a:r>
          </a:p>
        </p:txBody>
      </p:sp>
      <p:graphicFrame>
        <p:nvGraphicFramePr>
          <p:cNvPr id="28" name="对象 27"/>
          <p:cNvGraphicFramePr/>
          <p:nvPr/>
        </p:nvGraphicFramePr>
        <p:xfrm>
          <a:off x="560390" y="8042647"/>
          <a:ext cx="1371600" cy="14630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7" name="Prism 9" r:id="rId11" imgW="2990850" imgH="2984500" progId="Prism9.Document">
                  <p:embed/>
                </p:oleObj>
              </mc:Choice>
              <mc:Fallback>
                <p:oleObj name="Prism 9" r:id="rId11" imgW="2990850" imgH="2984500" progId="Prism9.Document">
                  <p:embed/>
                  <p:pic>
                    <p:nvPicPr>
                      <p:cNvPr id="0" name="对象 27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12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60390" y="8042647"/>
                        <a:ext cx="1371600" cy="146304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对象 28"/>
          <p:cNvGraphicFramePr/>
          <p:nvPr/>
        </p:nvGraphicFramePr>
        <p:xfrm>
          <a:off x="2101850" y="8042647"/>
          <a:ext cx="1371600" cy="14630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8" name="Prism 9" r:id="rId13" imgW="2908300" imgH="2984500" progId="Prism9.Document">
                  <p:embed/>
                </p:oleObj>
              </mc:Choice>
              <mc:Fallback>
                <p:oleObj name="Prism 9" r:id="rId13" imgW="2908300" imgH="2984500" progId="Prism9.Document">
                  <p:embed/>
                  <p:pic>
                    <p:nvPicPr>
                      <p:cNvPr id="0" name="对象 28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1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101850" y="8042647"/>
                        <a:ext cx="1371600" cy="146304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对象 29"/>
          <p:cNvGraphicFramePr/>
          <p:nvPr/>
        </p:nvGraphicFramePr>
        <p:xfrm>
          <a:off x="3402013" y="8042647"/>
          <a:ext cx="1371600" cy="14630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9" name="Prism 9" r:id="rId15" imgW="2838450" imgH="2984500" progId="Prism9.Document">
                  <p:embed/>
                </p:oleObj>
              </mc:Choice>
              <mc:Fallback>
                <p:oleObj name="Prism 9" r:id="rId15" imgW="2838450" imgH="2984500" progId="Prism9.Document">
                  <p:embed/>
                  <p:pic>
                    <p:nvPicPr>
                      <p:cNvPr id="0" name="对象 29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1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402013" y="8042647"/>
                        <a:ext cx="1371600" cy="146304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对象 30"/>
          <p:cNvGraphicFramePr/>
          <p:nvPr/>
        </p:nvGraphicFramePr>
        <p:xfrm>
          <a:off x="4900499" y="8042647"/>
          <a:ext cx="1371600" cy="14630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0" name="Prism 9" r:id="rId17" imgW="2762250" imgH="2984500" progId="Prism9.Document">
                  <p:embed/>
                </p:oleObj>
              </mc:Choice>
              <mc:Fallback>
                <p:oleObj name="Prism 9" r:id="rId17" imgW="2762250" imgH="2984500" progId="Prism9.Document">
                  <p:embed/>
                  <p:pic>
                    <p:nvPicPr>
                      <p:cNvPr id="0" name="对象 30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1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900499" y="8042647"/>
                        <a:ext cx="1371600" cy="146304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TextBox 1"/>
          <p:cNvSpPr txBox="1"/>
          <p:nvPr/>
        </p:nvSpPr>
        <p:spPr>
          <a:xfrm>
            <a:off x="271800" y="3108248"/>
            <a:ext cx="282511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Black" panose="020B0A04020102020204" pitchFamily="34" charset="0"/>
              </a:rPr>
              <a:t>b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ile acids in the 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intestine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3"/>
          <p:cNvSpPr txBox="1"/>
          <p:nvPr/>
        </p:nvSpPr>
        <p:spPr>
          <a:xfrm>
            <a:off x="271800" y="7627350"/>
            <a:ext cx="250952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Black" panose="020B0A04020102020204" pitchFamily="34" charset="0"/>
              </a:rPr>
              <a:t>d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ile acids in the 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feces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2" name="图表 21"/>
          <p:cNvGraphicFramePr/>
          <p:nvPr/>
        </p:nvGraphicFramePr>
        <p:xfrm>
          <a:off x="388346" y="820870"/>
          <a:ext cx="3600000" cy="19441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graphicFrame>
        <p:nvGraphicFramePr>
          <p:cNvPr id="23" name="图表 22"/>
          <p:cNvGraphicFramePr/>
          <p:nvPr/>
        </p:nvGraphicFramePr>
        <p:xfrm>
          <a:off x="3370190" y="820870"/>
          <a:ext cx="3600000" cy="19415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0"/>
          </a:graphicData>
        </a:graphic>
      </p:graphicFrame>
      <p:graphicFrame>
        <p:nvGraphicFramePr>
          <p:cNvPr id="27" name="图表 26"/>
          <p:cNvGraphicFramePr/>
          <p:nvPr/>
        </p:nvGraphicFramePr>
        <p:xfrm>
          <a:off x="969656" y="2248552"/>
          <a:ext cx="5779971" cy="8055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1"/>
          </a:graphicData>
        </a:graphic>
      </p:graphicFrame>
      <p:graphicFrame>
        <p:nvGraphicFramePr>
          <p:cNvPr id="33" name="图表 32"/>
          <p:cNvGraphicFramePr/>
          <p:nvPr/>
        </p:nvGraphicFramePr>
        <p:xfrm>
          <a:off x="388346" y="5289972"/>
          <a:ext cx="3600000" cy="1940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2"/>
          </a:graphicData>
        </a:graphic>
      </p:graphicFrame>
      <p:graphicFrame>
        <p:nvGraphicFramePr>
          <p:cNvPr id="34" name="图表 33"/>
          <p:cNvGraphicFramePr/>
          <p:nvPr/>
        </p:nvGraphicFramePr>
        <p:xfrm>
          <a:off x="3370190" y="5289972"/>
          <a:ext cx="3600000" cy="1940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3"/>
          </a:graphicData>
        </a:graphic>
      </p:graphicFrame>
      <p:graphicFrame>
        <p:nvGraphicFramePr>
          <p:cNvPr id="35" name="图表 34"/>
          <p:cNvGraphicFramePr/>
          <p:nvPr/>
        </p:nvGraphicFramePr>
        <p:xfrm>
          <a:off x="1172513" y="6914887"/>
          <a:ext cx="5551714" cy="990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4"/>
          </a:graphicData>
        </a:graphic>
      </p:graphicFrame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86927" y="122716"/>
            <a:ext cx="15349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 Black" panose="020B0A04020102020204" pitchFamily="34" charset="0"/>
              </a:rPr>
              <a:t>Figure S13</a:t>
            </a:r>
          </a:p>
        </p:txBody>
      </p:sp>
      <p:graphicFrame>
        <p:nvGraphicFramePr>
          <p:cNvPr id="4" name="Object 3"/>
          <p:cNvGraphicFramePr/>
          <p:nvPr/>
        </p:nvGraphicFramePr>
        <p:xfrm>
          <a:off x="2662238" y="3408363"/>
          <a:ext cx="2055812" cy="1812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436" name="Prism 9" r:id="rId3" imgW="2749550" imgH="2406650" progId="Prism9.Document">
                  <p:embed/>
                </p:oleObj>
              </mc:Choice>
              <mc:Fallback>
                <p:oleObj name="Prism 9" r:id="rId3" imgW="2749550" imgH="2406650" progId="Prism9.Document">
                  <p:embed/>
                  <p:pic>
                    <p:nvPicPr>
                      <p:cNvPr id="0" name="Object 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662238" y="3408363"/>
                        <a:ext cx="2055812" cy="1812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/>
        </p:nvGraphicFramePr>
        <p:xfrm>
          <a:off x="4441825" y="3408363"/>
          <a:ext cx="2060575" cy="1812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437" name="Prism 9" r:id="rId5" imgW="2736850" imgH="2406650" progId="Prism9.Document">
                  <p:embed/>
                </p:oleObj>
              </mc:Choice>
              <mc:Fallback>
                <p:oleObj name="Prism 9" r:id="rId5" imgW="2736850" imgH="2406650" progId="Prism9.Document">
                  <p:embed/>
                  <p:pic>
                    <p:nvPicPr>
                      <p:cNvPr id="0" name="Object 5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441825" y="3408363"/>
                        <a:ext cx="2060575" cy="1812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/>
        </p:nvGraphicFramePr>
        <p:xfrm>
          <a:off x="862013" y="3408363"/>
          <a:ext cx="2060575" cy="1812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438" name="Prism 9" r:id="rId7" imgW="2736850" imgH="2406650" progId="Prism9.Document">
                  <p:embed/>
                </p:oleObj>
              </mc:Choice>
              <mc:Fallback>
                <p:oleObj name="Prism 9" r:id="rId7" imgW="2736850" imgH="2406650" progId="Prism9.Document">
                  <p:embed/>
                  <p:pic>
                    <p:nvPicPr>
                      <p:cNvPr id="0" name="Object 6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62013" y="3408363"/>
                        <a:ext cx="2060575" cy="1812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/>
        </p:nvGraphicFramePr>
        <p:xfrm>
          <a:off x="2660650" y="5186363"/>
          <a:ext cx="2062163" cy="1812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439" name="Prism 9" r:id="rId9" imgW="2736850" imgH="2406650" progId="Prism9.Document">
                  <p:embed/>
                </p:oleObj>
              </mc:Choice>
              <mc:Fallback>
                <p:oleObj name="Prism 9" r:id="rId9" imgW="2736850" imgH="2406650" progId="Prism9.Document">
                  <p:embed/>
                  <p:pic>
                    <p:nvPicPr>
                      <p:cNvPr id="0" name="Object 8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660650" y="5186363"/>
                        <a:ext cx="2062163" cy="1812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9"/>
          <p:cNvGraphicFramePr>
            <a:graphicFrameLocks noChangeAspect="1"/>
          </p:cNvGraphicFramePr>
          <p:nvPr/>
        </p:nvGraphicFramePr>
        <p:xfrm>
          <a:off x="4486275" y="5189538"/>
          <a:ext cx="1970088" cy="18113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440" name="Prism 9" r:id="rId11" imgW="2616200" imgH="2406650" progId="Prism9.Document">
                  <p:embed/>
                </p:oleObj>
              </mc:Choice>
              <mc:Fallback>
                <p:oleObj name="Prism 9" r:id="rId11" imgW="2616200" imgH="2406650" progId="Prism9.Document">
                  <p:embed/>
                  <p:pic>
                    <p:nvPicPr>
                      <p:cNvPr id="0" name="Object 9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486275" y="5189538"/>
                        <a:ext cx="1970088" cy="18113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2"/>
          <p:cNvGraphicFramePr>
            <a:graphicFrameLocks noChangeAspect="1"/>
          </p:cNvGraphicFramePr>
          <p:nvPr/>
        </p:nvGraphicFramePr>
        <p:xfrm>
          <a:off x="862013" y="1724025"/>
          <a:ext cx="2060575" cy="1812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441" name="Prism 9" r:id="rId13" imgW="2736850" imgH="2406650" progId="Prism9.Document">
                  <p:embed/>
                </p:oleObj>
              </mc:Choice>
              <mc:Fallback>
                <p:oleObj name="Prism 9" r:id="rId13" imgW="2736850" imgH="2406650" progId="Prism9.Document">
                  <p:embed/>
                  <p:pic>
                    <p:nvPicPr>
                      <p:cNvPr id="0" name="Object 2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862013" y="1724025"/>
                        <a:ext cx="2060575" cy="1812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3"/>
          <p:cNvGraphicFramePr/>
          <p:nvPr/>
        </p:nvGraphicFramePr>
        <p:xfrm>
          <a:off x="2663825" y="1724025"/>
          <a:ext cx="2062163" cy="1812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442" name="Prism 9" r:id="rId15" imgW="2736850" imgH="2406650" progId="Prism9.Document">
                  <p:embed/>
                </p:oleObj>
              </mc:Choice>
              <mc:Fallback>
                <p:oleObj name="Prism 9" r:id="rId15" imgW="2736850" imgH="2406650" progId="Prism9.Document">
                  <p:embed/>
                  <p:pic>
                    <p:nvPicPr>
                      <p:cNvPr id="0" name="Object 13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2663825" y="1724025"/>
                        <a:ext cx="2062163" cy="1812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4"/>
          <p:cNvGraphicFramePr/>
          <p:nvPr/>
        </p:nvGraphicFramePr>
        <p:xfrm>
          <a:off x="4438650" y="1724025"/>
          <a:ext cx="2055813" cy="1812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443" name="Prism 9" r:id="rId17" imgW="2749550" imgH="2406650" progId="Prism9.Document">
                  <p:embed/>
                </p:oleObj>
              </mc:Choice>
              <mc:Fallback>
                <p:oleObj name="Prism 9" r:id="rId17" imgW="2749550" imgH="2406650" progId="Prism9.Document">
                  <p:embed/>
                  <p:pic>
                    <p:nvPicPr>
                      <p:cNvPr id="0" name="Object 14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4438650" y="1724025"/>
                        <a:ext cx="2055813" cy="1812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TextBox 77"/>
          <p:cNvSpPr txBox="1"/>
          <p:nvPr/>
        </p:nvSpPr>
        <p:spPr>
          <a:xfrm>
            <a:off x="362885" y="1610888"/>
            <a:ext cx="21275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 Black" panose="020B0A04020102020204" pitchFamily="34" charset="0"/>
              </a:rPr>
              <a:t>a</a:t>
            </a:r>
          </a:p>
        </p:txBody>
      </p:sp>
      <p:sp>
        <p:nvSpPr>
          <p:cNvPr id="20" name="TextBox 60"/>
          <p:cNvSpPr txBox="1"/>
          <p:nvPr/>
        </p:nvSpPr>
        <p:spPr>
          <a:xfrm>
            <a:off x="362885" y="5087977"/>
            <a:ext cx="21275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 Black" panose="020B0A04020102020204" pitchFamily="34" charset="0"/>
              </a:rPr>
              <a:t>b</a:t>
            </a:r>
          </a:p>
        </p:txBody>
      </p:sp>
      <p:graphicFrame>
        <p:nvGraphicFramePr>
          <p:cNvPr id="21" name="对象 20"/>
          <p:cNvGraphicFramePr>
            <a:graphicFrameLocks noChangeAspect="1"/>
          </p:cNvGraphicFramePr>
          <p:nvPr/>
        </p:nvGraphicFramePr>
        <p:xfrm>
          <a:off x="862013" y="5175250"/>
          <a:ext cx="2089150" cy="1838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444" name="Prism 9" r:id="rId19" imgW="2736850" imgH="2406650" progId="Prism9.Document">
                  <p:embed/>
                </p:oleObj>
              </mc:Choice>
              <mc:Fallback>
                <p:oleObj name="Prism 9" r:id="rId19" imgW="2736850" imgH="2406650" progId="Prism9.Document">
                  <p:embed/>
                  <p:pic>
                    <p:nvPicPr>
                      <p:cNvPr id="0" name="对象 20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862013" y="5175250"/>
                        <a:ext cx="2089150" cy="1838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900259" y="4412516"/>
            <a:ext cx="1847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0" y="218943"/>
            <a:ext cx="18287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 Black" panose="020B0A04020102020204" pitchFamily="34" charset="0"/>
              </a:rPr>
              <a:t>Figure S14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1084990" y="1144625"/>
            <a:ext cx="31813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 Black" panose="020B0A04020102020204" pitchFamily="34" charset="0"/>
              </a:rPr>
              <a:t>a</a:t>
            </a:r>
          </a:p>
        </p:txBody>
      </p:sp>
      <p:graphicFrame>
        <p:nvGraphicFramePr>
          <p:cNvPr id="29" name="对象 5"/>
          <p:cNvGraphicFramePr>
            <a:graphicFrameLocks noChangeAspect="1"/>
          </p:cNvGraphicFramePr>
          <p:nvPr/>
        </p:nvGraphicFramePr>
        <p:xfrm>
          <a:off x="1729403" y="1563653"/>
          <a:ext cx="3587973" cy="24260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439" name="Prism 10" r:id="rId3" imgW="4000500" imgH="2705100" progId="Prism10.Document">
                  <p:embed/>
                </p:oleObj>
              </mc:Choice>
              <mc:Fallback>
                <p:oleObj name="Prism 10" r:id="rId3" imgW="4000500" imgH="2705100" progId="Prism10.Document">
                  <p:embed/>
                  <p:pic>
                    <p:nvPicPr>
                      <p:cNvPr id="0" name="对象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729403" y="1563653"/>
                        <a:ext cx="3587973" cy="242604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对象 1"/>
          <p:cNvGraphicFramePr>
            <a:graphicFrameLocks noChangeAspect="1"/>
          </p:cNvGraphicFramePr>
          <p:nvPr/>
        </p:nvGraphicFramePr>
        <p:xfrm>
          <a:off x="593725" y="4257675"/>
          <a:ext cx="5857875" cy="3781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440" name="Prism 9" r:id="rId5" imgW="9423400" imgH="6089650" progId="Prism9.Document">
                  <p:embed/>
                </p:oleObj>
              </mc:Choice>
              <mc:Fallback>
                <p:oleObj name="Prism 9" r:id="rId5" imgW="9423400" imgH="6089650" progId="Prism9.Document">
                  <p:embed/>
                  <p:pic>
                    <p:nvPicPr>
                      <p:cNvPr id="0" name="对象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93725" y="4257675"/>
                        <a:ext cx="5857875" cy="37814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1" name="TextBox 16"/>
          <p:cNvSpPr txBox="1"/>
          <p:nvPr/>
        </p:nvSpPr>
        <p:spPr>
          <a:xfrm>
            <a:off x="1180927" y="4227850"/>
            <a:ext cx="31813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 Black" panose="020B0A04020102020204" pitchFamily="34" charset="0"/>
              </a:rPr>
              <a:t>b</a:t>
            </a:r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5"/>
          <p:cNvSpPr txBox="1"/>
          <p:nvPr/>
        </p:nvSpPr>
        <p:spPr>
          <a:xfrm>
            <a:off x="0" y="218943"/>
            <a:ext cx="18287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 Black" panose="020B0A04020102020204" pitchFamily="34" charset="0"/>
              </a:rPr>
              <a:t>Figure S15</a:t>
            </a:r>
          </a:p>
        </p:txBody>
      </p:sp>
      <p:pic>
        <p:nvPicPr>
          <p:cNvPr id="10" name="图片 9" descr="图标&#10;&#10;描述已自动生成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4224" y="1005864"/>
            <a:ext cx="5200522" cy="3464497"/>
          </a:xfrm>
          <a:prstGeom prst="rect">
            <a:avLst/>
          </a:prstGeom>
        </p:spPr>
      </p:pic>
      <p:sp>
        <p:nvSpPr>
          <p:cNvPr id="13" name="TextBox 16"/>
          <p:cNvSpPr txBox="1"/>
          <p:nvPr/>
        </p:nvSpPr>
        <p:spPr>
          <a:xfrm>
            <a:off x="66957" y="1031361"/>
            <a:ext cx="31813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 Black" panose="020B0A04020102020204" pitchFamily="34" charset="0"/>
              </a:rPr>
              <a:t>a</a:t>
            </a:r>
          </a:p>
        </p:txBody>
      </p:sp>
      <p:sp>
        <p:nvSpPr>
          <p:cNvPr id="14" name="TextBox 16"/>
          <p:cNvSpPr txBox="1"/>
          <p:nvPr/>
        </p:nvSpPr>
        <p:spPr>
          <a:xfrm>
            <a:off x="66957" y="4872539"/>
            <a:ext cx="31813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 Black" panose="020B0A04020102020204" pitchFamily="34" charset="0"/>
              </a:rPr>
              <a:t>b</a:t>
            </a:r>
          </a:p>
        </p:txBody>
      </p:sp>
      <p:sp>
        <p:nvSpPr>
          <p:cNvPr id="16" name="文本框 15"/>
          <p:cNvSpPr txBox="1"/>
          <p:nvPr/>
        </p:nvSpPr>
        <p:spPr>
          <a:xfrm>
            <a:off x="811499" y="1024513"/>
            <a:ext cx="40005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3432160" y="1024513"/>
            <a:ext cx="40005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811499" y="2545539"/>
            <a:ext cx="38989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3432160" y="2545539"/>
            <a:ext cx="40005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0" name="图表 19"/>
          <p:cNvGraphicFramePr/>
          <p:nvPr/>
        </p:nvGraphicFramePr>
        <p:xfrm>
          <a:off x="4379900" y="8266846"/>
          <a:ext cx="2592288" cy="21602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2" name="图表 21"/>
          <p:cNvGraphicFramePr/>
          <p:nvPr/>
        </p:nvGraphicFramePr>
        <p:xfrm>
          <a:off x="3844695" y="8578838"/>
          <a:ext cx="2420051" cy="18482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pSp>
        <p:nvGrpSpPr>
          <p:cNvPr id="7" name="组合 6"/>
          <p:cNvGrpSpPr/>
          <p:nvPr/>
        </p:nvGrpSpPr>
        <p:grpSpPr>
          <a:xfrm>
            <a:off x="811530" y="4888230"/>
            <a:ext cx="6449695" cy="4545330"/>
            <a:chOff x="1278" y="7698"/>
            <a:chExt cx="10157" cy="7158"/>
          </a:xfrm>
        </p:grpSpPr>
        <p:pic>
          <p:nvPicPr>
            <p:cNvPr id="12" name="图片 11" descr="图表, 散点图&#10;&#10;描述已自动生成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30" y="7707"/>
              <a:ext cx="10105" cy="7149"/>
            </a:xfrm>
            <a:prstGeom prst="rect">
              <a:avLst/>
            </a:prstGeom>
          </p:spPr>
        </p:pic>
        <p:sp>
          <p:nvSpPr>
            <p:cNvPr id="2" name="文本框 1"/>
            <p:cNvSpPr txBox="1"/>
            <p:nvPr>
              <p:custDataLst>
                <p:tags r:id="rId1"/>
              </p:custDataLst>
            </p:nvPr>
          </p:nvSpPr>
          <p:spPr>
            <a:xfrm>
              <a:off x="1278" y="7698"/>
              <a:ext cx="630" cy="483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 anchor="t" anchorCtr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文本框 2"/>
            <p:cNvSpPr txBox="1"/>
            <p:nvPr>
              <p:custDataLst>
                <p:tags r:id="rId2"/>
              </p:custDataLst>
            </p:nvPr>
          </p:nvSpPr>
          <p:spPr>
            <a:xfrm>
              <a:off x="5384" y="7730"/>
              <a:ext cx="732" cy="483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 anchor="t" anchorCtr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文本框 4"/>
            <p:cNvSpPr txBox="1"/>
            <p:nvPr>
              <p:custDataLst>
                <p:tags r:id="rId3"/>
              </p:custDataLst>
            </p:nvPr>
          </p:nvSpPr>
          <p:spPr>
            <a:xfrm>
              <a:off x="1289" y="11132"/>
              <a:ext cx="614" cy="483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 anchor="t" anchorCtr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(c)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/>
            <p:cNvSpPr txBox="1"/>
            <p:nvPr>
              <p:custDataLst>
                <p:tags r:id="rId4"/>
              </p:custDataLst>
            </p:nvPr>
          </p:nvSpPr>
          <p:spPr>
            <a:xfrm>
              <a:off x="5395" y="11164"/>
              <a:ext cx="732" cy="483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 anchor="t" anchorCtr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(d)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图表 5"/>
          <p:cNvGraphicFramePr/>
          <p:nvPr/>
        </p:nvGraphicFramePr>
        <p:xfrm>
          <a:off x="4307566" y="2500908"/>
          <a:ext cx="2592288" cy="21602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" name="图表 12"/>
          <p:cNvGraphicFramePr/>
          <p:nvPr/>
        </p:nvGraphicFramePr>
        <p:xfrm>
          <a:off x="4479803" y="2766393"/>
          <a:ext cx="2420051" cy="18482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14" name="组合 13"/>
          <p:cNvGrpSpPr/>
          <p:nvPr/>
        </p:nvGrpSpPr>
        <p:grpSpPr>
          <a:xfrm>
            <a:off x="1596538" y="4373116"/>
            <a:ext cx="3888432" cy="792088"/>
            <a:chOff x="2771800" y="3861048"/>
            <a:chExt cx="3888432" cy="792088"/>
          </a:xfrm>
        </p:grpSpPr>
        <p:graphicFrame>
          <p:nvGraphicFramePr>
            <p:cNvPr id="15" name="图表 14"/>
            <p:cNvGraphicFramePr/>
            <p:nvPr/>
          </p:nvGraphicFramePr>
          <p:xfrm>
            <a:off x="2771800" y="3861048"/>
            <a:ext cx="3888432" cy="79208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6" name="矩形 15"/>
            <p:cNvSpPr/>
            <p:nvPr/>
          </p:nvSpPr>
          <p:spPr>
            <a:xfrm>
              <a:off x="3131840" y="4109075"/>
              <a:ext cx="3312368" cy="2880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2400"/>
            </a:p>
          </p:txBody>
        </p:sp>
      </p:grpSp>
      <p:sp>
        <p:nvSpPr>
          <p:cNvPr id="17" name="TextBox 15"/>
          <p:cNvSpPr txBox="1"/>
          <p:nvPr/>
        </p:nvSpPr>
        <p:spPr>
          <a:xfrm>
            <a:off x="0" y="218943"/>
            <a:ext cx="18287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 Black" panose="020B0A04020102020204" pitchFamily="34" charset="0"/>
              </a:rPr>
              <a:t>Figure S16</a:t>
            </a:r>
          </a:p>
        </p:txBody>
      </p:sp>
      <p:graphicFrame>
        <p:nvGraphicFramePr>
          <p:cNvPr id="21" name="图表 20"/>
          <p:cNvGraphicFramePr/>
          <p:nvPr/>
        </p:nvGraphicFramePr>
        <p:xfrm>
          <a:off x="-179338" y="2506577"/>
          <a:ext cx="3053296" cy="18805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2" name="图表 21"/>
          <p:cNvGraphicFramePr/>
          <p:nvPr/>
        </p:nvGraphicFramePr>
        <p:xfrm>
          <a:off x="2130952" y="2506577"/>
          <a:ext cx="3053296" cy="18805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3" name="图表 22"/>
          <p:cNvGraphicFramePr/>
          <p:nvPr/>
        </p:nvGraphicFramePr>
        <p:xfrm>
          <a:off x="4364772" y="2506577"/>
          <a:ext cx="3053296" cy="18805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217396" y="122358"/>
            <a:ext cx="13810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 Black" panose="020B0A04020102020204" pitchFamily="34" charset="0"/>
              </a:rPr>
              <a:t>Figure S2</a:t>
            </a:r>
          </a:p>
        </p:txBody>
      </p:sp>
      <p:grpSp>
        <p:nvGrpSpPr>
          <p:cNvPr id="6" name="Group 5"/>
          <p:cNvGrpSpPr/>
          <p:nvPr/>
        </p:nvGrpSpPr>
        <p:grpSpPr>
          <a:xfrm>
            <a:off x="640939" y="1028700"/>
            <a:ext cx="2534061" cy="3302282"/>
            <a:chOff x="504459" y="1028700"/>
            <a:chExt cx="2534061" cy="3302282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" t="4390" r="26634"/>
            <a:stretch>
              <a:fillRect/>
            </a:stretch>
          </p:blipFill>
          <p:spPr>
            <a:xfrm>
              <a:off x="504459" y="1028700"/>
              <a:ext cx="2534061" cy="3302282"/>
            </a:xfrm>
            <a:prstGeom prst="rect">
              <a:avLst/>
            </a:prstGeom>
          </p:spPr>
        </p:pic>
        <p:sp>
          <p:nvSpPr>
            <p:cNvPr id="35" name="Rectangle 34"/>
            <p:cNvSpPr/>
            <p:nvPr/>
          </p:nvSpPr>
          <p:spPr>
            <a:xfrm>
              <a:off x="908785" y="4140793"/>
              <a:ext cx="1882540" cy="19018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7" name="标题 1"/>
          <p:cNvSpPr txBox="1"/>
          <p:nvPr/>
        </p:nvSpPr>
        <p:spPr>
          <a:xfrm>
            <a:off x="489244" y="8620740"/>
            <a:ext cx="6329479" cy="848832"/>
          </a:xfrm>
          <a:prstGeom prst="rect">
            <a:avLst/>
          </a:prstGeom>
        </p:spPr>
        <p:txBody>
          <a:bodyPr>
            <a:noAutofit/>
          </a:bodyPr>
          <a:lstStyle>
            <a:lvl1pPr algn="l" defTabSz="73152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52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150000"/>
              </a:lnSpc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enn diagram of differentially expressed genes (FC ≥ 2 and p-value &lt; 0.05)  of the two comparisons: Mdr2</a:t>
            </a:r>
            <a:r>
              <a:rPr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vs. WT and BBR-treated vs. Control Mdr2</a:t>
            </a:r>
            <a:r>
              <a:rPr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mice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52172" y="679408"/>
            <a:ext cx="308087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 Black" panose="020B0A04020102020204" pitchFamily="34" charset="0"/>
              </a:rPr>
              <a:t>a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686932" y="679408"/>
            <a:ext cx="308087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 Black" panose="020B0A04020102020204" pitchFamily="34" charset="0"/>
              </a:rPr>
              <a:t>b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452172" y="4612171"/>
            <a:ext cx="308087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 Black" panose="020B0A04020102020204" pitchFamily="34" charset="0"/>
              </a:rPr>
              <a:t>c</a:t>
            </a:r>
          </a:p>
        </p:txBody>
      </p:sp>
      <p:graphicFrame>
        <p:nvGraphicFramePr>
          <p:cNvPr id="32" name="对象 32"/>
          <p:cNvGraphicFramePr>
            <a:graphicFrameLocks noChangeAspect="1"/>
          </p:cNvGraphicFramePr>
          <p:nvPr/>
        </p:nvGraphicFramePr>
        <p:xfrm>
          <a:off x="3830638" y="912813"/>
          <a:ext cx="2865437" cy="3405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68" name="Prism 9" r:id="rId4" imgW="2838450" imgH="3371850" progId="Prism9.Document">
                  <p:embed/>
                </p:oleObj>
              </mc:Choice>
              <mc:Fallback>
                <p:oleObj name="Prism 9" r:id="rId4" imgW="2838450" imgH="3371850" progId="Prism9.Document">
                  <p:embed/>
                  <p:pic>
                    <p:nvPicPr>
                      <p:cNvPr id="0" name="对象 3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30638" y="912813"/>
                        <a:ext cx="2865437" cy="34051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Rectangle 14"/>
          <p:cNvSpPr/>
          <p:nvPr/>
        </p:nvSpPr>
        <p:spPr>
          <a:xfrm>
            <a:off x="2121340" y="780827"/>
            <a:ext cx="76174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      BBR </a:t>
            </a:r>
            <a:endParaRPr lang="en-US" sz="1100" dirty="0"/>
          </a:p>
        </p:txBody>
      </p:sp>
      <p:sp>
        <p:nvSpPr>
          <p:cNvPr id="16" name="Rectangle 15"/>
          <p:cNvSpPr/>
          <p:nvPr/>
        </p:nvSpPr>
        <p:spPr>
          <a:xfrm>
            <a:off x="1510734" y="780827"/>
            <a:ext cx="75212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 Control</a:t>
            </a:r>
            <a:endParaRPr lang="en-US" sz="1100" dirty="0"/>
          </a:p>
        </p:txBody>
      </p:sp>
      <p:sp>
        <p:nvSpPr>
          <p:cNvPr id="25" name="Rectangle 24"/>
          <p:cNvSpPr/>
          <p:nvPr/>
        </p:nvSpPr>
        <p:spPr>
          <a:xfrm>
            <a:off x="1061876" y="767090"/>
            <a:ext cx="44275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 WT</a:t>
            </a:r>
            <a:endParaRPr lang="en-US" sz="1100" dirty="0"/>
          </a:p>
        </p:txBody>
      </p:sp>
      <p:cxnSp>
        <p:nvCxnSpPr>
          <p:cNvPr id="26" name="直接连接符 25"/>
          <p:cNvCxnSpPr/>
          <p:nvPr/>
        </p:nvCxnSpPr>
        <p:spPr>
          <a:xfrm>
            <a:off x="1076318" y="1013126"/>
            <a:ext cx="4572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接连接符 28"/>
          <p:cNvCxnSpPr/>
          <p:nvPr/>
        </p:nvCxnSpPr>
        <p:spPr>
          <a:xfrm>
            <a:off x="1555290" y="1012518"/>
            <a:ext cx="66402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连接符 29"/>
          <p:cNvCxnSpPr/>
          <p:nvPr/>
        </p:nvCxnSpPr>
        <p:spPr>
          <a:xfrm>
            <a:off x="2273746" y="1012518"/>
            <a:ext cx="66402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" name="组合 2"/>
          <p:cNvGrpSpPr/>
          <p:nvPr/>
        </p:nvGrpSpPr>
        <p:grpSpPr>
          <a:xfrm>
            <a:off x="832560" y="4727557"/>
            <a:ext cx="5141052" cy="3760370"/>
            <a:chOff x="832560" y="4727557"/>
            <a:chExt cx="5141052" cy="3760370"/>
          </a:xfrm>
        </p:grpSpPr>
        <p:grpSp>
          <p:nvGrpSpPr>
            <p:cNvPr id="18" name="Group 17"/>
            <p:cNvGrpSpPr/>
            <p:nvPr/>
          </p:nvGrpSpPr>
          <p:grpSpPr>
            <a:xfrm>
              <a:off x="832560" y="4727557"/>
              <a:ext cx="5141052" cy="3760370"/>
              <a:chOff x="846224" y="4425792"/>
              <a:chExt cx="5141052" cy="3760370"/>
            </a:xfrm>
          </p:grpSpPr>
          <p:pic>
            <p:nvPicPr>
              <p:cNvPr id="19" name="Picture 18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46224" y="4555489"/>
                <a:ext cx="4840897" cy="3630673"/>
              </a:xfrm>
              <a:prstGeom prst="rect">
                <a:avLst/>
              </a:prstGeom>
            </p:spPr>
          </p:pic>
          <p:sp>
            <p:nvSpPr>
              <p:cNvPr id="20" name="TextBox 19"/>
              <p:cNvSpPr txBox="1"/>
              <p:nvPr/>
            </p:nvSpPr>
            <p:spPr>
              <a:xfrm>
                <a:off x="931299" y="4667614"/>
                <a:ext cx="1769116" cy="81560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dr2</a:t>
                </a:r>
                <a:r>
                  <a:rPr lang="en-US" altLang="zh-CN" sz="14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/-</a:t>
                </a:r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vs. WT</a:t>
                </a:r>
              </a:p>
              <a:p>
                <a:r>
                  <a:rPr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otal: 1937</a:t>
                </a:r>
              </a:p>
              <a:p>
                <a:r>
                  <a:rPr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Up-regulated:1260</a:t>
                </a:r>
              </a:p>
              <a:p>
                <a:r>
                  <a:rPr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own-regulated:677</a:t>
                </a: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3667647" y="4425792"/>
                <a:ext cx="2319629" cy="103105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Mdr2</a:t>
                </a:r>
                <a:r>
                  <a:rPr lang="en-US" altLang="zh-CN" sz="14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/-</a:t>
                </a:r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mice</a:t>
                </a:r>
              </a:p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BR vs. Control</a:t>
                </a:r>
              </a:p>
              <a:p>
                <a:r>
                  <a:rPr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otal: 587</a:t>
                </a:r>
              </a:p>
              <a:p>
                <a:r>
                  <a:rPr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Up-regulated:300</a:t>
                </a:r>
              </a:p>
              <a:p>
                <a:r>
                  <a:rPr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own-regulated:287</a:t>
                </a:r>
              </a:p>
            </p:txBody>
          </p:sp>
        </p:grpSp>
        <p:sp>
          <p:nvSpPr>
            <p:cNvPr id="4" name="文本框 3"/>
            <p:cNvSpPr txBox="1"/>
            <p:nvPr/>
          </p:nvSpPr>
          <p:spPr>
            <a:xfrm>
              <a:off x="1998448" y="7888623"/>
              <a:ext cx="1641743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Mdr2</a:t>
              </a:r>
              <a:r>
                <a:rPr lang="en-US" altLang="zh-CN" sz="14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vs.WT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4066556" y="7387880"/>
              <a:ext cx="1641743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BR vs. Control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7" name="直接连接符 28"/>
          <p:cNvCxnSpPr/>
          <p:nvPr/>
        </p:nvCxnSpPr>
        <p:spPr>
          <a:xfrm>
            <a:off x="1598834" y="767090"/>
            <a:ext cx="128425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1793283" y="484023"/>
            <a:ext cx="89346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>
                <a:latin typeface="Arial Black" panose="020B0A04020102020204" pitchFamily="34" charset="0"/>
              </a:rPr>
              <a:t>Mdr2</a:t>
            </a:r>
            <a:r>
              <a:rPr lang="en-US" sz="1400" baseline="30000" dirty="0">
                <a:latin typeface="Arial Black" panose="020B0A04020102020204" pitchFamily="34" charset="0"/>
              </a:rPr>
              <a:t>-/- </a:t>
            </a:r>
            <a:endParaRPr lang="en-US" sz="1400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1285875" y="1500138"/>
            <a:ext cx="5218112" cy="6650086"/>
            <a:chOff x="788281" y="393060"/>
            <a:chExt cx="4828656" cy="5857229"/>
          </a:xfrm>
        </p:grpSpPr>
        <p:graphicFrame>
          <p:nvGraphicFramePr>
            <p:cNvPr id="14" name="对象 13"/>
            <p:cNvGraphicFramePr>
              <a:graphicFrameLocks noChangeAspect="1"/>
            </p:cNvGraphicFramePr>
            <p:nvPr/>
          </p:nvGraphicFramePr>
          <p:xfrm>
            <a:off x="1399392" y="622414"/>
            <a:ext cx="4217545" cy="269019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295" name="Prism 9" r:id="rId3" imgW="7423150" imgH="4368800" progId="Prism9.Document">
                    <p:embed/>
                  </p:oleObj>
                </mc:Choice>
                <mc:Fallback>
                  <p:oleObj name="Prism 9" r:id="rId3" imgW="7423150" imgH="4368800" progId="Prism9.Document">
                    <p:embed/>
                    <p:pic>
                      <p:nvPicPr>
                        <p:cNvPr id="0" name="对象 13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399392" y="622414"/>
                          <a:ext cx="4217545" cy="269019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6" name="组合 5"/>
            <p:cNvGrpSpPr/>
            <p:nvPr/>
          </p:nvGrpSpPr>
          <p:grpSpPr>
            <a:xfrm>
              <a:off x="1975514" y="393060"/>
              <a:ext cx="3364172" cy="276999"/>
              <a:chOff x="2129906" y="1042600"/>
              <a:chExt cx="3364172" cy="276999"/>
            </a:xfrm>
          </p:grpSpPr>
          <p:cxnSp>
            <p:nvCxnSpPr>
              <p:cNvPr id="10" name="直接箭头连接符 9"/>
              <p:cNvCxnSpPr/>
              <p:nvPr/>
            </p:nvCxnSpPr>
            <p:spPr>
              <a:xfrm>
                <a:off x="3787198" y="1181100"/>
                <a:ext cx="853440" cy="0"/>
              </a:xfrm>
              <a:prstGeom prst="straightConnector1">
                <a:avLst/>
              </a:prstGeom>
              <a:ln w="38100">
                <a:solidFill>
                  <a:srgbClr val="A0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" name="文本框 10"/>
              <p:cNvSpPr txBox="1"/>
              <p:nvPr/>
            </p:nvSpPr>
            <p:spPr>
              <a:xfrm>
                <a:off x="4640638" y="1042600"/>
                <a:ext cx="853440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rgbClr val="A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ctivation</a:t>
                </a:r>
                <a:endParaRPr lang="zh-CN" altLang="en-US" sz="1200" dirty="0">
                  <a:solidFill>
                    <a:srgbClr val="A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2" name="直接箭头连接符 11"/>
              <p:cNvCxnSpPr/>
              <p:nvPr/>
            </p:nvCxnSpPr>
            <p:spPr>
              <a:xfrm flipH="1">
                <a:off x="2129906" y="1181100"/>
                <a:ext cx="853440" cy="0"/>
              </a:xfrm>
              <a:prstGeom prst="straightConnector1">
                <a:avLst/>
              </a:prstGeom>
              <a:ln w="38100">
                <a:solidFill>
                  <a:srgbClr val="00008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文本框 12"/>
              <p:cNvSpPr txBox="1"/>
              <p:nvPr/>
            </p:nvSpPr>
            <p:spPr>
              <a:xfrm>
                <a:off x="2983346" y="1042600"/>
                <a:ext cx="853440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rgbClr val="00008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nhibition</a:t>
                </a:r>
                <a:endParaRPr lang="zh-CN" altLang="en-US" sz="1200" dirty="0">
                  <a:solidFill>
                    <a:srgbClr val="00008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aphicFrame>
          <p:nvGraphicFramePr>
            <p:cNvPr id="8" name="对象 7"/>
            <p:cNvGraphicFramePr>
              <a:graphicFrameLocks noChangeAspect="1"/>
            </p:cNvGraphicFramePr>
            <p:nvPr/>
          </p:nvGraphicFramePr>
          <p:xfrm>
            <a:off x="788281" y="3340573"/>
            <a:ext cx="4154378" cy="290971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296" name="Prism 9" r:id="rId5" imgW="7042150" imgH="4349750" progId="Prism9.Document">
                    <p:embed/>
                  </p:oleObj>
                </mc:Choice>
                <mc:Fallback>
                  <p:oleObj name="Prism 9" r:id="rId5" imgW="7042150" imgH="4349750" progId="Prism9.Document">
                    <p:embed/>
                    <p:pic>
                      <p:nvPicPr>
                        <p:cNvPr id="0" name="对象 7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788281" y="3340573"/>
                          <a:ext cx="4154378" cy="290971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6" name="文本框 15"/>
          <p:cNvSpPr txBox="1"/>
          <p:nvPr/>
        </p:nvSpPr>
        <p:spPr>
          <a:xfrm>
            <a:off x="366520" y="9152598"/>
            <a:ext cx="7171509" cy="41601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6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Top 10 significantly pathways based on ingenuity pathway analysis (IPA) </a:t>
            </a:r>
            <a:endParaRPr lang="zh-CN" altLang="en-US" sz="16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5" name="TextBox 1"/>
          <p:cNvSpPr txBox="1"/>
          <p:nvPr/>
        </p:nvSpPr>
        <p:spPr>
          <a:xfrm>
            <a:off x="217396" y="122358"/>
            <a:ext cx="14579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 Black" panose="020B0A04020102020204" pitchFamily="34" charset="0"/>
              </a:rPr>
              <a:t>Figure S3 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6524" y="2891247"/>
            <a:ext cx="2698032" cy="12801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65847" y="2891247"/>
            <a:ext cx="2698032" cy="128016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文本框 7"/>
          <p:cNvSpPr txBox="1"/>
          <p:nvPr/>
        </p:nvSpPr>
        <p:spPr>
          <a:xfrm>
            <a:off x="451648" y="3393554"/>
            <a:ext cx="1220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Raw images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531798" y="4567886"/>
            <a:ext cx="114005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Processed </a:t>
            </a:r>
          </a:p>
          <a:p>
            <a:pPr algn="ct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images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773218" y="2521628"/>
            <a:ext cx="23142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icro-Sirius Red staining 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970217" y="2521629"/>
            <a:ext cx="1770800" cy="307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K19 IHC staining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86927" y="122716"/>
            <a:ext cx="13810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 Black" panose="020B0A04020102020204" pitchFamily="34" charset="0"/>
              </a:rPr>
              <a:t>Figure S4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614969" y="2850329"/>
            <a:ext cx="327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334745" y="2850329"/>
            <a:ext cx="327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65847" y="4210224"/>
            <a:ext cx="2698032" cy="12801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6524" y="4210224"/>
            <a:ext cx="2698032" cy="128016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6" name="TextBox 15"/>
          <p:cNvSpPr txBox="1"/>
          <p:nvPr/>
        </p:nvSpPr>
        <p:spPr>
          <a:xfrm>
            <a:off x="1614969" y="4157711"/>
            <a:ext cx="327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4334745" y="4157711"/>
            <a:ext cx="2551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843669" y="2503473"/>
            <a:ext cx="21275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 Black" panose="020B0A04020102020204" pitchFamily="34" charset="0"/>
              </a:rPr>
              <a:t>a</a:t>
            </a:r>
          </a:p>
        </p:txBody>
      </p:sp>
      <p:graphicFrame>
        <p:nvGraphicFramePr>
          <p:cNvPr id="19" name="Object 18"/>
          <p:cNvGraphicFramePr>
            <a:graphicFrameLocks noChangeAspect="1"/>
          </p:cNvGraphicFramePr>
          <p:nvPr/>
        </p:nvGraphicFramePr>
        <p:xfrm>
          <a:off x="2424113" y="6081713"/>
          <a:ext cx="3336925" cy="2427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16" name="Prism 9" r:id="rId8" imgW="3345180" imgH="2438400" progId="Prism9.Document">
                  <p:embed/>
                </p:oleObj>
              </mc:Choice>
              <mc:Fallback>
                <p:oleObj name="Prism 9" r:id="rId8" imgW="3345180" imgH="2438400" progId="Prism9.Document">
                  <p:embed/>
                  <p:pic>
                    <p:nvPicPr>
                      <p:cNvPr id="0" name="Object 18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424113" y="6081713"/>
                        <a:ext cx="3336925" cy="2427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TextBox 21"/>
          <p:cNvSpPr txBox="1"/>
          <p:nvPr/>
        </p:nvSpPr>
        <p:spPr>
          <a:xfrm>
            <a:off x="777436" y="6068560"/>
            <a:ext cx="21275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 Black" panose="020B0A04020102020204" pitchFamily="34" charset="0"/>
              </a:rPr>
              <a:t>b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/>
        </p:nvGraphicFramePr>
        <p:xfrm>
          <a:off x="1095375" y="706438"/>
          <a:ext cx="3055938" cy="5213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67" name="Prism 10" r:id="rId3" imgW="3985260" imgH="6781800" progId="Prism10.Document">
                  <p:embed/>
                </p:oleObj>
              </mc:Choice>
              <mc:Fallback>
                <p:oleObj name="Prism 10" r:id="rId3" imgW="3985260" imgH="6781800" progId="Prism10.Document">
                  <p:embed/>
                  <p:pic>
                    <p:nvPicPr>
                      <p:cNvPr id="0" name="Objec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95375" y="706438"/>
                        <a:ext cx="3055938" cy="5213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/>
        </p:nvGraphicFramePr>
        <p:xfrm>
          <a:off x="4316413" y="2247900"/>
          <a:ext cx="2189162" cy="18557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68" name="Prism 9" r:id="rId5" imgW="2876550" imgH="2438400" progId="Prism9.Document">
                  <p:embed/>
                </p:oleObj>
              </mc:Choice>
              <mc:Fallback>
                <p:oleObj name="Prism 9" r:id="rId5" imgW="2876550" imgH="2438400" progId="Prism9.Document">
                  <p:embed/>
                  <p:pic>
                    <p:nvPicPr>
                      <p:cNvPr id="0" name="Object 3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316413" y="2247900"/>
                        <a:ext cx="2189162" cy="18557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4"/>
          <p:cNvGraphicFramePr>
            <a:graphicFrameLocks noChangeAspect="1"/>
          </p:cNvGraphicFramePr>
          <p:nvPr/>
        </p:nvGraphicFramePr>
        <p:xfrm>
          <a:off x="4316413" y="3798888"/>
          <a:ext cx="2189162" cy="1852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69" name="Prism 9" r:id="rId7" imgW="2876550" imgH="2438400" progId="Prism9.Document">
                  <p:embed/>
                </p:oleObj>
              </mc:Choice>
              <mc:Fallback>
                <p:oleObj name="Prism 9" r:id="rId7" imgW="2876550" imgH="2438400" progId="Prism9.Document">
                  <p:embed/>
                  <p:pic>
                    <p:nvPicPr>
                      <p:cNvPr id="0" name="Object 4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316413" y="3798888"/>
                        <a:ext cx="2189162" cy="18526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5"/>
          <p:cNvGraphicFramePr>
            <a:graphicFrameLocks noChangeAspect="1"/>
          </p:cNvGraphicFramePr>
          <p:nvPr/>
        </p:nvGraphicFramePr>
        <p:xfrm>
          <a:off x="4316413" y="669925"/>
          <a:ext cx="2189162" cy="1854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70" name="Prism 9" r:id="rId9" imgW="2876550" imgH="2438400" progId="Prism9.Document">
                  <p:embed/>
                </p:oleObj>
              </mc:Choice>
              <mc:Fallback>
                <p:oleObj name="Prism 9" r:id="rId9" imgW="2876550" imgH="2438400" progId="Prism9.Document">
                  <p:embed/>
                  <p:pic>
                    <p:nvPicPr>
                      <p:cNvPr id="0" name="Object 5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316413" y="669925"/>
                        <a:ext cx="2189162" cy="1854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6"/>
          <p:cNvGraphicFramePr/>
          <p:nvPr/>
        </p:nvGraphicFramePr>
        <p:xfrm>
          <a:off x="762000" y="5518150"/>
          <a:ext cx="2212975" cy="18557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71" name="Prism 9" r:id="rId11" imgW="2794000" imgH="2438400" progId="Prism9.Document">
                  <p:embed/>
                </p:oleObj>
              </mc:Choice>
              <mc:Fallback>
                <p:oleObj name="Prism 9" r:id="rId11" imgW="2794000" imgH="2438400" progId="Prism9.Document">
                  <p:embed/>
                  <p:pic>
                    <p:nvPicPr>
                      <p:cNvPr id="0" name="Object 6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762000" y="5518150"/>
                        <a:ext cx="2212975" cy="18557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7"/>
          <p:cNvGraphicFramePr/>
          <p:nvPr/>
        </p:nvGraphicFramePr>
        <p:xfrm>
          <a:off x="2519363" y="5518150"/>
          <a:ext cx="2212975" cy="18557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72" name="Prism 9" r:id="rId13" imgW="2794000" imgH="2438400" progId="Prism9.Document">
                  <p:embed/>
                </p:oleObj>
              </mc:Choice>
              <mc:Fallback>
                <p:oleObj name="Prism 9" r:id="rId13" imgW="2794000" imgH="2438400" progId="Prism9.Document">
                  <p:embed/>
                  <p:pic>
                    <p:nvPicPr>
                      <p:cNvPr id="0" name="Object 7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2519363" y="5518150"/>
                        <a:ext cx="2212975" cy="18557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8"/>
          <p:cNvGraphicFramePr>
            <a:graphicFrameLocks noChangeAspect="1"/>
          </p:cNvGraphicFramePr>
          <p:nvPr/>
        </p:nvGraphicFramePr>
        <p:xfrm>
          <a:off x="4303713" y="5518150"/>
          <a:ext cx="2216150" cy="18557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73" name="Prism 9" r:id="rId15" imgW="2914650" imgH="2438400" progId="Prism9.Document">
                  <p:embed/>
                </p:oleObj>
              </mc:Choice>
              <mc:Fallback>
                <p:oleObj name="Prism 9" r:id="rId15" imgW="2914650" imgH="2438400" progId="Prism9.Document">
                  <p:embed/>
                  <p:pic>
                    <p:nvPicPr>
                      <p:cNvPr id="0" name="Object 8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303713" y="5518150"/>
                        <a:ext cx="2216150" cy="18557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9"/>
          <p:cNvGraphicFramePr>
            <a:graphicFrameLocks noChangeAspect="1"/>
          </p:cNvGraphicFramePr>
          <p:nvPr/>
        </p:nvGraphicFramePr>
        <p:xfrm>
          <a:off x="758825" y="7224713"/>
          <a:ext cx="2216150" cy="1852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74" name="Prism 9" r:id="rId17" imgW="2914650" imgH="2438400" progId="Prism9.Document">
                  <p:embed/>
                </p:oleObj>
              </mc:Choice>
              <mc:Fallback>
                <p:oleObj name="Prism 9" r:id="rId17" imgW="2914650" imgH="2438400" progId="Prism9.Document">
                  <p:embed/>
                  <p:pic>
                    <p:nvPicPr>
                      <p:cNvPr id="0" name="Object 9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758825" y="7224713"/>
                        <a:ext cx="2216150" cy="18526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2"/>
          <p:cNvGraphicFramePr>
            <a:graphicFrameLocks noChangeAspect="1"/>
          </p:cNvGraphicFramePr>
          <p:nvPr/>
        </p:nvGraphicFramePr>
        <p:xfrm>
          <a:off x="4316413" y="7221538"/>
          <a:ext cx="2189162" cy="18557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75" name="Prism 9" r:id="rId19" imgW="2876550" imgH="2438400" progId="Prism9.Document">
                  <p:embed/>
                </p:oleObj>
              </mc:Choice>
              <mc:Fallback>
                <p:oleObj name="Prism 9" r:id="rId19" imgW="2876550" imgH="2438400" progId="Prism9.Document">
                  <p:embed/>
                  <p:pic>
                    <p:nvPicPr>
                      <p:cNvPr id="0" name="Object 12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4316413" y="7221538"/>
                        <a:ext cx="2189162" cy="18557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TextBox 13"/>
          <p:cNvSpPr txBox="1"/>
          <p:nvPr/>
        </p:nvSpPr>
        <p:spPr>
          <a:xfrm>
            <a:off x="86927" y="122716"/>
            <a:ext cx="13810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 Black" panose="020B0A04020102020204" pitchFamily="34" charset="0"/>
              </a:rPr>
              <a:t>Figure S5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827822" y="640742"/>
            <a:ext cx="21275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 Black" panose="020B0A04020102020204" pitchFamily="34" charset="0"/>
              </a:rPr>
              <a:t>a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052770" y="640742"/>
            <a:ext cx="21275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 Black" panose="020B0A04020102020204" pitchFamily="34" charset="0"/>
              </a:rPr>
              <a:t>b</a:t>
            </a:r>
          </a:p>
        </p:txBody>
      </p:sp>
      <p:graphicFrame>
        <p:nvGraphicFramePr>
          <p:cNvPr id="23" name="Object 47"/>
          <p:cNvGraphicFramePr>
            <a:graphicFrameLocks noChangeAspect="1"/>
          </p:cNvGraphicFramePr>
          <p:nvPr/>
        </p:nvGraphicFramePr>
        <p:xfrm>
          <a:off x="2530475" y="7221538"/>
          <a:ext cx="2189163" cy="18557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76" name="Prism 9" r:id="rId21" imgW="2876550" imgH="2438400" progId="Prism9.Document">
                  <p:embed/>
                </p:oleObj>
              </mc:Choice>
              <mc:Fallback>
                <p:oleObj name="Prism 9" r:id="rId21" imgW="2876550" imgH="2438400" progId="Prism9.Document">
                  <p:embed/>
                  <p:pic>
                    <p:nvPicPr>
                      <p:cNvPr id="0" name="Object 47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2530475" y="7221538"/>
                        <a:ext cx="2189163" cy="18557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对象 1"/>
          <p:cNvGraphicFramePr>
            <a:graphicFrameLocks noChangeAspect="1"/>
          </p:cNvGraphicFramePr>
          <p:nvPr/>
        </p:nvGraphicFramePr>
        <p:xfrm>
          <a:off x="1847850" y="1728788"/>
          <a:ext cx="3608388" cy="66627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364" name="Prism 10" r:id="rId3" imgW="4244340" imgH="7833360" progId="Prism10.Document">
                  <p:embed/>
                </p:oleObj>
              </mc:Choice>
              <mc:Fallback>
                <p:oleObj name="Prism 10" r:id="rId3" imgW="4244340" imgH="7833360" progId="Prism10.Document">
                  <p:embed/>
                  <p:pic>
                    <p:nvPicPr>
                      <p:cNvPr id="0" name="对象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47850" y="1728788"/>
                        <a:ext cx="3608388" cy="66627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217396" y="122358"/>
            <a:ext cx="13810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 Black" panose="020B0A04020102020204" pitchFamily="34" charset="0"/>
              </a:rPr>
              <a:t>Figure </a:t>
            </a:r>
            <a:r>
              <a:rPr lang="en-US" altLang="zh-CN" dirty="0">
                <a:latin typeface="Arial Black" panose="020B0A04020102020204" pitchFamily="34" charset="0"/>
              </a:rPr>
              <a:t>S6</a:t>
            </a:r>
            <a:endParaRPr lang="en-US" dirty="0">
              <a:latin typeface="Arial Black" panose="020B0A04020102020204" pitchFamily="34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5"/>
          <p:cNvSpPr txBox="1"/>
          <p:nvPr/>
        </p:nvSpPr>
        <p:spPr>
          <a:xfrm>
            <a:off x="1976199" y="793104"/>
            <a:ext cx="3349136" cy="350865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68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NF-kappa B signaling pathway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17396" y="122358"/>
            <a:ext cx="13810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 Black" panose="020B0A04020102020204" pitchFamily="34" charset="0"/>
              </a:rPr>
              <a:t>Figure </a:t>
            </a:r>
            <a:r>
              <a:rPr lang="en-US" altLang="zh-CN" dirty="0">
                <a:latin typeface="Arial Black" panose="020B0A04020102020204" pitchFamily="34" charset="0"/>
              </a:rPr>
              <a:t>S7</a:t>
            </a:r>
            <a:endParaRPr lang="en-US" dirty="0">
              <a:latin typeface="Arial Black" panose="020B0A04020102020204" pitchFamily="34" charset="0"/>
            </a:endParaRPr>
          </a:p>
        </p:txBody>
      </p:sp>
      <p:pic>
        <p:nvPicPr>
          <p:cNvPr id="7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1738" y="1143969"/>
            <a:ext cx="4770053" cy="4159301"/>
          </a:xfrm>
          <a:prstGeom prst="rect">
            <a:avLst/>
          </a:prstGeom>
        </p:spPr>
      </p:pic>
      <p:pic>
        <p:nvPicPr>
          <p:cNvPr id="8" name="图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1738" y="5428076"/>
            <a:ext cx="4770053" cy="4159301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18399" y="7180806"/>
            <a:ext cx="136447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/>
            <a:r>
              <a:rPr lang="en-US" sz="1200" b="1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BR vs. Control</a:t>
            </a:r>
          </a:p>
        </p:txBody>
      </p:sp>
      <p:sp>
        <p:nvSpPr>
          <p:cNvPr id="10" name="Rectangle 9"/>
          <p:cNvSpPr/>
          <p:nvPr/>
        </p:nvSpPr>
        <p:spPr>
          <a:xfrm>
            <a:off x="30930" y="2876369"/>
            <a:ext cx="123142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/>
            <a:r>
              <a:rPr lang="en-US" sz="1200" b="1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dr2</a:t>
            </a:r>
            <a:r>
              <a:rPr lang="en-US" sz="1200" b="1" kern="100" baseline="300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-/-</a:t>
            </a:r>
            <a:r>
              <a:rPr lang="en-US" sz="1200" b="1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vs. WT</a:t>
            </a: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4513" y="1030390"/>
            <a:ext cx="5459188" cy="4238802"/>
          </a:xfrm>
          <a:prstGeom prst="rect">
            <a:avLst/>
          </a:prstGeom>
        </p:spPr>
      </p:pic>
      <p:pic>
        <p:nvPicPr>
          <p:cNvPr id="4" name="图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4512" y="5373520"/>
            <a:ext cx="5455694" cy="4236090"/>
          </a:xfrm>
          <a:prstGeom prst="rect">
            <a:avLst/>
          </a:prstGeom>
        </p:spPr>
      </p:pic>
      <p:sp>
        <p:nvSpPr>
          <p:cNvPr id="5" name="文本框 5"/>
          <p:cNvSpPr txBox="1"/>
          <p:nvPr/>
        </p:nvSpPr>
        <p:spPr>
          <a:xfrm>
            <a:off x="2582245" y="679525"/>
            <a:ext cx="2808461" cy="3508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80" dirty="0">
                <a:latin typeface="Arial" panose="020B0604020202020204" pitchFamily="34" charset="0"/>
                <a:cs typeface="Arial" panose="020B0604020202020204" pitchFamily="34" charset="0"/>
              </a:rPr>
              <a:t>MAPK signaling pathway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17396" y="122358"/>
            <a:ext cx="13810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 Black" panose="020B0A04020102020204" pitchFamily="34" charset="0"/>
              </a:rPr>
              <a:t>Figure </a:t>
            </a:r>
            <a:r>
              <a:rPr lang="en-US" altLang="zh-CN" dirty="0">
                <a:latin typeface="Arial Black" panose="020B0A04020102020204" pitchFamily="34" charset="0"/>
              </a:rPr>
              <a:t>S8</a:t>
            </a:r>
            <a:endParaRPr lang="en-US" dirty="0">
              <a:latin typeface="Arial Black" panose="020B0A04020102020204" pitchFamily="34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18399" y="7180806"/>
            <a:ext cx="136447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/>
            <a:r>
              <a:rPr lang="en-US" sz="1200" b="1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BR vs. Control</a:t>
            </a:r>
          </a:p>
        </p:txBody>
      </p:sp>
      <p:sp>
        <p:nvSpPr>
          <p:cNvPr id="11" name="Rectangle 10"/>
          <p:cNvSpPr/>
          <p:nvPr/>
        </p:nvSpPr>
        <p:spPr>
          <a:xfrm>
            <a:off x="30930" y="2876369"/>
            <a:ext cx="123142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/>
            <a:r>
              <a:rPr lang="en-US" sz="1200" b="1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dr2</a:t>
            </a:r>
            <a:r>
              <a:rPr lang="en-US" sz="1200" b="1" kern="100" baseline="300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-/-</a:t>
            </a:r>
            <a:r>
              <a:rPr lang="en-US" sz="1200" b="1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vs. WT</a:t>
            </a: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1771" y="1267927"/>
            <a:ext cx="5852160" cy="4009897"/>
          </a:xfrm>
          <a:prstGeom prst="rect">
            <a:avLst/>
          </a:prstGeom>
        </p:spPr>
      </p:pic>
      <p:pic>
        <p:nvPicPr>
          <p:cNvPr id="6" name="图片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1771" y="5350014"/>
            <a:ext cx="5852160" cy="4009897"/>
          </a:xfrm>
          <a:prstGeom prst="rect">
            <a:avLst/>
          </a:prstGeom>
        </p:spPr>
      </p:pic>
      <p:sp>
        <p:nvSpPr>
          <p:cNvPr id="4" name="文本框 4"/>
          <p:cNvSpPr txBox="1"/>
          <p:nvPr/>
        </p:nvSpPr>
        <p:spPr>
          <a:xfrm>
            <a:off x="2085334" y="798443"/>
            <a:ext cx="3727040" cy="3508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80" dirty="0"/>
              <a:t>	</a:t>
            </a:r>
            <a:r>
              <a:rPr lang="en-US" sz="1680" dirty="0">
                <a:latin typeface="Arial" panose="020B0604020202020204" pitchFamily="34" charset="0"/>
                <a:cs typeface="Arial" panose="020B0604020202020204" pitchFamily="34" charset="0"/>
              </a:rPr>
              <a:t>Oxidative phosphorylation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17396" y="122358"/>
            <a:ext cx="13810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 Black" panose="020B0A04020102020204" pitchFamily="34" charset="0"/>
              </a:rPr>
              <a:t>Figure </a:t>
            </a:r>
            <a:r>
              <a:rPr lang="en-US" altLang="zh-CN" dirty="0">
                <a:latin typeface="Arial Black" panose="020B0A04020102020204" pitchFamily="34" charset="0"/>
              </a:rPr>
              <a:t>S9</a:t>
            </a:r>
            <a:endParaRPr lang="en-US" dirty="0">
              <a:latin typeface="Arial Black" panose="020B0A04020102020204" pitchFamily="34" charset="0"/>
            </a:endParaRPr>
          </a:p>
        </p:txBody>
      </p:sp>
      <p:sp>
        <p:nvSpPr>
          <p:cNvPr id="10" name="Rectangle 8"/>
          <p:cNvSpPr/>
          <p:nvPr/>
        </p:nvSpPr>
        <p:spPr>
          <a:xfrm>
            <a:off x="-48005" y="7180806"/>
            <a:ext cx="136447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/>
            <a:r>
              <a:rPr lang="en-US" sz="1200" b="1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BR vs. Control</a:t>
            </a:r>
          </a:p>
        </p:txBody>
      </p:sp>
      <p:sp>
        <p:nvSpPr>
          <p:cNvPr id="8" name="Rectangle 7"/>
          <p:cNvSpPr/>
          <p:nvPr/>
        </p:nvSpPr>
        <p:spPr>
          <a:xfrm>
            <a:off x="30930" y="2876369"/>
            <a:ext cx="123142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/>
            <a:r>
              <a:rPr lang="en-US" sz="1200" b="1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dr2</a:t>
            </a:r>
            <a:r>
              <a:rPr lang="en-US" sz="1200" b="1" kern="100" baseline="300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-/-</a:t>
            </a:r>
            <a:r>
              <a:rPr lang="en-US" sz="1200" b="1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vs. WT</a:t>
            </a: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MjFmMWQ2Y2JhYjA2NWYzMDYwNDg1YWJkNmIwMDIzYzgifQ==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1F4F367B864454591B4910AED6213C3" ma:contentTypeVersion="10" ma:contentTypeDescription="Create a new document." ma:contentTypeScope="" ma:versionID="96fb4b0f1815b693df0b44fd0d144908">
  <xsd:schema xmlns:xsd="http://www.w3.org/2001/XMLSchema" xmlns:xs="http://www.w3.org/2001/XMLSchema" xmlns:p="http://schemas.microsoft.com/office/2006/metadata/properties" xmlns:ns3="7de81b9c-fe01-4808-af79-f8f5274ba5c7" targetNamespace="http://schemas.microsoft.com/office/2006/metadata/properties" ma:root="true" ma:fieldsID="1a3b47586051a90e492eb3be5c979f0f" ns3:_="">
    <xsd:import namespace="7de81b9c-fe01-4808-af79-f8f5274ba5c7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AutoKeyPoints" minOccurs="0"/>
                <xsd:element ref="ns3:MediaServiceKeyPoints" minOccurs="0"/>
                <xsd:element ref="ns3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de81b9c-fe01-4808-af79-f8f5274ba5c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AA60347E-B936-4117-8C9D-62E9CC402409}">
  <ds:schemaRefs/>
</ds:datastoreItem>
</file>

<file path=customXml/itemProps2.xml><?xml version="1.0" encoding="utf-8"?>
<ds:datastoreItem xmlns:ds="http://schemas.openxmlformats.org/officeDocument/2006/customXml" ds:itemID="{F9053E79-BC3A-40E3-B0A5-817BF76545FB}">
  <ds:schemaRefs/>
</ds:datastoreItem>
</file>

<file path=customXml/itemProps3.xml><?xml version="1.0" encoding="utf-8"?>
<ds:datastoreItem xmlns:ds="http://schemas.openxmlformats.org/officeDocument/2006/customXml" ds:itemID="{20D84C18-1A02-454D-8953-DE2AF1812C9B}">
  <ds:schemaRefs/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Figures-4-23-2021-Fig1-7-MDR2+BBR</Template>
  <TotalTime>25</TotalTime>
  <Words>294</Words>
  <Application>Microsoft Office PowerPoint</Application>
  <PresentationFormat>Custom</PresentationFormat>
  <Paragraphs>97</Paragraphs>
  <Slides>16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6</vt:i4>
      </vt:variant>
    </vt:vector>
  </HeadingPairs>
  <TitlesOfParts>
    <vt:vector size="23" baseType="lpstr">
      <vt:lpstr>Arial</vt:lpstr>
      <vt:lpstr>Arial Black</vt:lpstr>
      <vt:lpstr>Calibri</vt:lpstr>
      <vt:lpstr>Calibri Light</vt:lpstr>
      <vt:lpstr>Office 主题​​</vt:lpstr>
      <vt:lpstr>Prism 9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Virginia Commonwealth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ang Yanyan</dc:creator>
  <cp:lastModifiedBy>Huiping Zhou</cp:lastModifiedBy>
  <cp:revision>224</cp:revision>
  <cp:lastPrinted>2023-11-27T01:41:00Z</cp:lastPrinted>
  <dcterms:created xsi:type="dcterms:W3CDTF">2021-05-07T00:58:00Z</dcterms:created>
  <dcterms:modified xsi:type="dcterms:W3CDTF">2023-12-31T20:58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1F4F367B864454591B4910AED6213C3</vt:lpwstr>
  </property>
  <property fmtid="{D5CDD505-2E9C-101B-9397-08002B2CF9AE}" pid="3" name="ICV">
    <vt:lpwstr>0DD3A6DCA04146469C4E91BC6413244A_12</vt:lpwstr>
  </property>
  <property fmtid="{D5CDD505-2E9C-101B-9397-08002B2CF9AE}" pid="4" name="KSOProductBuildVer">
    <vt:lpwstr>2052-12.1.0.16120</vt:lpwstr>
  </property>
</Properties>
</file>